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59" r:id="rId2"/>
    <p:sldId id="257" r:id="rId3"/>
    <p:sldId id="256" r:id="rId4"/>
    <p:sldId id="262" r:id="rId5"/>
    <p:sldId id="261" r:id="rId6"/>
    <p:sldId id="263" r:id="rId7"/>
    <p:sldId id="268" r:id="rId8"/>
    <p:sldId id="271" r:id="rId9"/>
    <p:sldId id="272" r:id="rId10"/>
    <p:sldId id="276" r:id="rId11"/>
    <p:sldId id="273" r:id="rId12"/>
    <p:sldId id="274" r:id="rId13"/>
    <p:sldId id="275" r:id="rId14"/>
    <p:sldId id="277" r:id="rId15"/>
    <p:sldId id="278" r:id="rId16"/>
    <p:sldId id="279" r:id="rId17"/>
    <p:sldId id="269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B572DD-2C2F-4825-9C25-E27190877452}" type="datetimeFigureOut">
              <a:rPr lang="en-US" smtClean="0"/>
              <a:t>5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C06618-09ED-4C68-B54C-726313EBFD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500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06618-09ED-4C68-B54C-726313EBFD5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8735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BC5089-33EC-6524-6ECD-6DF8C6E56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1B9B52-DE86-EDE3-DD12-2B0FA45184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9ECE2B-6EF4-9C77-DECF-E660CB502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06B426-88BF-3DE0-F5BC-825F976EA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C2F5D5-0221-CF5B-209B-14E4D195E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92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EC8E8-94DF-3F60-DB54-C722A6E14A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37D19B-F12D-B4FB-3AE4-0C00E7A06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B6247F-F0E7-C5B4-538B-BECDB1715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3D2157-06A9-DA32-568B-304D575A2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BF8825-A970-3D5D-8768-BBBF02835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871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0F3A3A-EF24-4F99-C739-762C3B302F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85E53A-4E81-2284-DDD2-F5985459D3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577E77-28C2-7D81-401F-C5CBBB04C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621CE-9A1B-0DAC-63DE-1FF3E3D78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D67BD-869A-D222-F35E-017CB1EF0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315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111F9-5E77-8552-21CB-92913B8BB7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476160-13BA-2F14-81E1-D288704514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A59338-31C6-DE0B-F622-BF0D19A4E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485C07-5B11-3A40-14ED-BE7184E67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F304A-FB1C-D5F7-91C0-EB290993E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128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FD308C-F196-4209-9FD7-62A49DA1B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B7A170-48AC-05DF-F634-A33EC5442F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CF5999-3D13-1757-B7FA-6389F66D4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A4CD3A-8D8E-DD3D-6921-B9A5C4CCE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CFC877-1087-4231-D07A-62CDD878D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645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6B155-4C5F-D46E-D74B-1A1CD41F89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F05B0A-6834-8E5F-C96C-CE420EBE80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97738B-8B49-1BC0-303B-2A346CBEAC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647D5F-E310-0FA0-F9AD-E30396F24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4B4848-F45E-38F2-8CBB-B363C7728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874E29-0F6B-86CA-76AD-8A6E81BF3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184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E7D53-B409-02A3-7F13-AB4CB2EBED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E0F0A5-ED09-CE1A-2F8D-F00736EA99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60FEC9-FE7A-448B-2427-54088B2819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34AF1F-58AD-40AD-023E-0F9F3AC0A6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EA2176-4D9A-5B95-0C2D-C5A70B50D5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CB426A-7D87-9EDC-65DF-BF2CF7B05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72E703-B797-B1F9-B0EA-4D86D9750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5543B0-1BBB-E400-EA04-B4C0BE59D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560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7683A-084C-CEAB-AEDB-CDD1B8B71A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973948-5CF5-3BCC-65CB-496C8A24A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F3187C-6DA7-BFAC-2571-5E94EC286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E17BB-831E-826B-72AF-81D75FC56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7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58F862-2E02-C6DB-B550-D6BD90E25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EAA4DD-F65C-B948-EF17-37F9A9086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FE750C-57E4-2EE1-A16B-00C65F751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929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900479-48F2-A17F-DAFF-D301CCC47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48B0BA-69C0-B99F-42E0-429FF080FD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D1DE14-F79C-9BD7-0CF0-9225202376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F561DA-C414-8B0D-39F6-35F8ACCDE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210EEE-C0EC-FDF8-1110-B01ADAB12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BD8087-81E2-CDB0-5D22-141CBC4F7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16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B0B28-5035-A3AD-2B75-EE213B4AD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FC62CC-6711-563D-8A18-503DE6C3D6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33EF76-C38D-8E67-C62B-1F7BE4C9F2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A7F0BC-F926-A674-94A6-2AE674FC1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67AC39-BD73-98AE-9881-12404A058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E1F3D5-8A11-FD16-0929-B749EDA67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895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253AD7-1601-B70D-2D29-1533A1C16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D25BE5-5DBC-6DB5-898E-9A3CC72F8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7EA595-9409-5945-ABC0-82A1CE1378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BEB4A-10CE-465C-928D-55A3A4A7D76D}" type="datetimeFigureOut">
              <a:rPr lang="en-US" smtClean="0"/>
              <a:t>5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F97BEB-2CA1-D09A-027B-7C6888DF78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8F914C-8020-2979-0F86-F843AC499B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9F526-BA5E-4FA7-B074-EB2F30DB4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95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0.png"/><Relationship Id="rId4" Type="http://schemas.openxmlformats.org/officeDocument/2006/relationships/image" Target="../media/image59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4.png"/><Relationship Id="rId4" Type="http://schemas.openxmlformats.org/officeDocument/2006/relationships/image" Target="../media/image6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5" Type="http://schemas.openxmlformats.org/officeDocument/2006/relationships/image" Target="../media/image68.png"/><Relationship Id="rId4" Type="http://schemas.openxmlformats.org/officeDocument/2006/relationships/image" Target="../media/image67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tif"/><Relationship Id="rId2" Type="http://schemas.openxmlformats.org/officeDocument/2006/relationships/image" Target="../media/image70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tif"/><Relationship Id="rId5" Type="http://schemas.openxmlformats.org/officeDocument/2006/relationships/image" Target="../media/image15.tif"/><Relationship Id="rId4" Type="http://schemas.openxmlformats.org/officeDocument/2006/relationships/image" Target="../media/image14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tif"/><Relationship Id="rId5" Type="http://schemas.openxmlformats.org/officeDocument/2006/relationships/image" Target="../media/image23.tif"/><Relationship Id="rId4" Type="http://schemas.openxmlformats.org/officeDocument/2006/relationships/image" Target="../media/image22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"/><Relationship Id="rId7" Type="http://schemas.openxmlformats.org/officeDocument/2006/relationships/image" Target="../media/image30.tif"/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tif"/><Relationship Id="rId5" Type="http://schemas.openxmlformats.org/officeDocument/2006/relationships/image" Target="../media/image28.tif"/><Relationship Id="rId4" Type="http://schemas.openxmlformats.org/officeDocument/2006/relationships/image" Target="../media/image27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text, device, measuring stick, gauge&#10;&#10;Description automatically generated">
            <a:extLst>
              <a:ext uri="{FF2B5EF4-FFF2-40B4-BE49-F238E27FC236}">
                <a16:creationId xmlns:a16="http://schemas.microsoft.com/office/drawing/2014/main" id="{12A5F03E-A95A-F379-6863-1B038624312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-9719" b="-15553"/>
          <a:stretch/>
        </p:blipFill>
        <p:spPr>
          <a:xfrm>
            <a:off x="759142" y="1230740"/>
            <a:ext cx="3709988" cy="2025174"/>
          </a:xfrm>
        </p:spPr>
      </p:pic>
      <p:pic>
        <p:nvPicPr>
          <p:cNvPr id="7" name="Picture 6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61BA6872-C662-BCB2-89E5-DDF7139F4C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" r="-4076" b="-15062"/>
          <a:stretch/>
        </p:blipFill>
        <p:spPr>
          <a:xfrm>
            <a:off x="6234882" y="1245303"/>
            <a:ext cx="3709988" cy="2555082"/>
          </a:xfrm>
          <a:prstGeom prst="rect">
            <a:avLst/>
          </a:prstGeom>
        </p:spPr>
      </p:pic>
      <p:pic>
        <p:nvPicPr>
          <p:cNvPr id="9" name="Picture 8" descr="A close-up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98FB6AEC-5006-3BAD-DA0A-D628346551C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1" r="-2385" b="-14927"/>
          <a:stretch/>
        </p:blipFill>
        <p:spPr>
          <a:xfrm>
            <a:off x="759142" y="4044475"/>
            <a:ext cx="3461984" cy="202517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D550F4F-6E82-3C8F-5F31-9BE5A383052B}"/>
              </a:ext>
            </a:extLst>
          </p:cNvPr>
          <p:cNvSpPr txBox="1"/>
          <p:nvPr/>
        </p:nvSpPr>
        <p:spPr>
          <a:xfrm>
            <a:off x="4012910" y="2559178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DGAT1 5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356486-BE31-6BE0-74B5-329D219E7B70}"/>
              </a:ext>
            </a:extLst>
          </p:cNvPr>
          <p:cNvSpPr txBox="1"/>
          <p:nvPr/>
        </p:nvSpPr>
        <p:spPr>
          <a:xfrm>
            <a:off x="4140517" y="4341892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GAPDH 38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DD269B-D21C-D48E-0524-56F0D6E123A5}"/>
              </a:ext>
            </a:extLst>
          </p:cNvPr>
          <p:cNvSpPr txBox="1"/>
          <p:nvPr/>
        </p:nvSpPr>
        <p:spPr>
          <a:xfrm>
            <a:off x="9695433" y="2676780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DGAT2 44 </a:t>
            </a:r>
            <a:r>
              <a:rPr lang="en-US" dirty="0" err="1"/>
              <a:t>kDa</a:t>
            </a:r>
            <a:endParaRPr lang="en-US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B3C2BAD-F4F7-6795-DAB7-124FAF66F058}"/>
              </a:ext>
            </a:extLst>
          </p:cNvPr>
          <p:cNvGrpSpPr/>
          <p:nvPr/>
        </p:nvGrpSpPr>
        <p:grpSpPr>
          <a:xfrm>
            <a:off x="6309024" y="985547"/>
            <a:ext cx="3561704" cy="468754"/>
            <a:chOff x="970839" y="418953"/>
            <a:chExt cx="3561704" cy="468754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B0FD443-F676-CAF5-247F-8D5EB572C002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8C8560E-8057-073E-6A83-2ED9691BF3F5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B1E8E6C-7BDA-F910-635D-64B92E45BD76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4FEE5A8-FAB6-72E4-3C5B-41F93171DF11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03F1731-6ABD-36A0-DACB-96B6FD12A3FC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1FBBA26-E2A3-A6A8-530D-B3553808676B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C88505E-2EA5-BF5A-CE92-2B15CCEC7286}"/>
              </a:ext>
            </a:extLst>
          </p:cNvPr>
          <p:cNvGrpSpPr/>
          <p:nvPr/>
        </p:nvGrpSpPr>
        <p:grpSpPr>
          <a:xfrm>
            <a:off x="939499" y="810739"/>
            <a:ext cx="3561704" cy="468754"/>
            <a:chOff x="970839" y="418953"/>
            <a:chExt cx="3561704" cy="468754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E998A23-D67A-6A01-6E98-71CB5DB12885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25798CD-F917-D4D0-CF30-9CD2B26C4530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EA4C75F-D0F0-CB25-7E48-74992687AB3F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508CD36-BEE1-9F3F-DC61-ABC31A0EA91D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4F9175F-5495-B05F-3438-94EAFB233681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43ABB0D-F9D9-8DC6-268D-BCAD84461737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E4B7EA09-FB69-E34E-FB66-4CA8E1CB105C}"/>
              </a:ext>
            </a:extLst>
          </p:cNvPr>
          <p:cNvGrpSpPr/>
          <p:nvPr/>
        </p:nvGrpSpPr>
        <p:grpSpPr>
          <a:xfrm>
            <a:off x="962346" y="3563044"/>
            <a:ext cx="3561704" cy="468754"/>
            <a:chOff x="970839" y="418953"/>
            <a:chExt cx="3561704" cy="468754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522AFD6-5C96-F8E4-17DA-829FB517B850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2C59137-1E6B-96FD-4931-34BCCBF185BD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85DDCFB-779E-2FAB-797D-89E2F961C269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0FA5677-1A4D-4DB1-F98F-EADE2A873FC3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3838438-B7B9-CAF7-4168-1AAEA71DFECA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05635A0-DDB9-859B-84F6-117572EBEC19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1DD0DE4C-04FE-EA70-85EB-34688AF593D9}"/>
              </a:ext>
            </a:extLst>
          </p:cNvPr>
          <p:cNvSpPr txBox="1"/>
          <p:nvPr/>
        </p:nvSpPr>
        <p:spPr>
          <a:xfrm>
            <a:off x="1494156" y="5884983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2CF00E-1E1F-F9C5-784E-4960BEAB147F}"/>
              </a:ext>
            </a:extLst>
          </p:cNvPr>
          <p:cNvSpPr txBox="1"/>
          <p:nvPr/>
        </p:nvSpPr>
        <p:spPr>
          <a:xfrm>
            <a:off x="7093898" y="3701806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FFE8E65-7FB5-5738-1417-D6EE4310F6ED}"/>
              </a:ext>
            </a:extLst>
          </p:cNvPr>
          <p:cNvSpPr/>
          <p:nvPr/>
        </p:nvSpPr>
        <p:spPr>
          <a:xfrm>
            <a:off x="1964311" y="2464067"/>
            <a:ext cx="838122" cy="46444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9842EE7-A3FC-C6A6-1497-6B6242BCC0A8}"/>
              </a:ext>
            </a:extLst>
          </p:cNvPr>
          <p:cNvSpPr/>
          <p:nvPr/>
        </p:nvSpPr>
        <p:spPr>
          <a:xfrm>
            <a:off x="7333836" y="2676780"/>
            <a:ext cx="772280" cy="47201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37F7366-7B49-2036-B81D-6D26912204F5}"/>
              </a:ext>
            </a:extLst>
          </p:cNvPr>
          <p:cNvSpPr txBox="1"/>
          <p:nvPr/>
        </p:nvSpPr>
        <p:spPr>
          <a:xfrm>
            <a:off x="4071662" y="2211240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B-C</a:t>
            </a:r>
            <a:endParaRPr lang="en-US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EC850DC-6A79-5560-39AF-7D89D788DB9D}"/>
              </a:ext>
            </a:extLst>
          </p:cNvPr>
          <p:cNvSpPr txBox="1"/>
          <p:nvPr/>
        </p:nvSpPr>
        <p:spPr>
          <a:xfrm>
            <a:off x="9695433" y="2291058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B-C</a:t>
            </a:r>
            <a:endParaRPr lang="en-US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D089502-27EE-7462-28F8-FCA799DA8C21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27283421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F45BAD-FDF7-4FA2-5615-C17CB82934EC}"/>
              </a:ext>
            </a:extLst>
          </p:cNvPr>
          <p:cNvSpPr txBox="1"/>
          <p:nvPr/>
        </p:nvSpPr>
        <p:spPr>
          <a:xfrm>
            <a:off x="3591136" y="6199780"/>
            <a:ext cx="4035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% Tris Glycine gel  run 3.5 hour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66941E5-DFC8-FC77-9CEC-70F6159BAC43}"/>
              </a:ext>
            </a:extLst>
          </p:cNvPr>
          <p:cNvSpPr txBox="1"/>
          <p:nvPr/>
        </p:nvSpPr>
        <p:spPr>
          <a:xfrm>
            <a:off x="3636723" y="220962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A</a:t>
            </a:r>
            <a:endParaRPr lang="en-US" b="1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662C9D5-7D48-2807-436E-8DC17A0BFA88}"/>
              </a:ext>
            </a:extLst>
          </p:cNvPr>
          <p:cNvGrpSpPr/>
          <p:nvPr/>
        </p:nvGrpSpPr>
        <p:grpSpPr>
          <a:xfrm>
            <a:off x="2716202" y="684394"/>
            <a:ext cx="7186585" cy="5440400"/>
            <a:chOff x="5515211" y="965243"/>
            <a:chExt cx="7186585" cy="54404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C7DF9F4-ED00-D05C-144D-EE888ADDDD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933167" y="3998736"/>
              <a:ext cx="2438611" cy="235935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D452D3B-DFE9-83F1-9A82-335C681F828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950445" y="1532699"/>
              <a:ext cx="2438611" cy="242032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271489B-68FD-AC7E-6CA2-19B344C659C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15211" y="4046287"/>
              <a:ext cx="2298391" cy="2359356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F2B3AB5-2336-F292-A886-55635FEA93A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515211" y="1531216"/>
              <a:ext cx="2304488" cy="2450804"/>
            </a:xfrm>
            <a:prstGeom prst="rect">
              <a:avLst/>
            </a:prstGeom>
          </p:spPr>
        </p:pic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FF67D3CD-8331-B15B-992B-B8E99FF04AA7}"/>
                </a:ext>
              </a:extLst>
            </p:cNvPr>
            <p:cNvCxnSpPr>
              <a:cxnSpLocks/>
            </p:cNvCxnSpPr>
            <p:nvPr/>
          </p:nvCxnSpPr>
          <p:spPr>
            <a:xfrm>
              <a:off x="5687553" y="2925448"/>
              <a:ext cx="52002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EDD15D51-EF6E-757F-FCD0-D41973CD6283}"/>
                </a:ext>
              </a:extLst>
            </p:cNvPr>
            <p:cNvGrpSpPr/>
            <p:nvPr/>
          </p:nvGrpSpPr>
          <p:grpSpPr>
            <a:xfrm>
              <a:off x="6138836" y="1491452"/>
              <a:ext cx="2062009" cy="523791"/>
              <a:chOff x="7993505" y="448576"/>
              <a:chExt cx="2062009" cy="523791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3A3A0A4-0FD9-166E-0668-16397D277D3F}"/>
                  </a:ext>
                </a:extLst>
              </p:cNvPr>
              <p:cNvSpPr txBox="1"/>
              <p:nvPr/>
            </p:nvSpPr>
            <p:spPr>
              <a:xfrm rot="18900000">
                <a:off x="7993505" y="603035"/>
                <a:ext cx="6944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/>
                  <a:t>siCon</a:t>
                </a:r>
                <a:endParaRPr lang="en-US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483357E-9C1B-1AD3-1057-0BBB5F684195}"/>
                  </a:ext>
                </a:extLst>
              </p:cNvPr>
              <p:cNvSpPr txBox="1"/>
              <p:nvPr/>
            </p:nvSpPr>
            <p:spPr>
              <a:xfrm rot="18900000">
                <a:off x="8385057" y="448576"/>
                <a:ext cx="11528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siPGC1A-1</a:t>
                </a:r>
                <a:endParaRPr lang="en-US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112F8E4C-47AD-B710-21DD-C5D501FCE1EF}"/>
                  </a:ext>
                </a:extLst>
              </p:cNvPr>
              <p:cNvSpPr txBox="1"/>
              <p:nvPr/>
            </p:nvSpPr>
            <p:spPr>
              <a:xfrm rot="18900000">
                <a:off x="8902634" y="453960"/>
                <a:ext cx="11528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siPGC1A-2</a:t>
                </a:r>
                <a:endParaRPr lang="en-US" dirty="0"/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8D07DD7-E5CC-0587-B0EB-B4835DBEA0B8}"/>
                </a:ext>
              </a:extLst>
            </p:cNvPr>
            <p:cNvSpPr txBox="1"/>
            <p:nvPr/>
          </p:nvSpPr>
          <p:spPr>
            <a:xfrm>
              <a:off x="10305737" y="2753681"/>
              <a:ext cx="188626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dirty="0"/>
                <a:t>PGC1</a:t>
              </a:r>
              <a:r>
                <a:rPr lang="en-US" sz="1800" dirty="0">
                  <a:latin typeface="Symbol" panose="05050102010706020507" pitchFamily="18" charset="2"/>
                </a:rPr>
                <a:t>a </a:t>
              </a:r>
              <a:r>
                <a:rPr lang="en-US" sz="1800" dirty="0"/>
                <a:t>77.14 </a:t>
              </a:r>
              <a:r>
                <a:rPr lang="en-US" sz="1800" dirty="0" err="1"/>
                <a:t>kDa</a:t>
              </a:r>
              <a:r>
                <a:rPr lang="en-US" sz="1800" dirty="0"/>
                <a:t> </a:t>
              </a:r>
              <a:endParaRPr lang="en-US" dirty="0"/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68E65C9C-E827-1061-820A-0BFCB228D3E7}"/>
                </a:ext>
              </a:extLst>
            </p:cNvPr>
            <p:cNvCxnSpPr>
              <a:cxnSpLocks/>
            </p:cNvCxnSpPr>
            <p:nvPr/>
          </p:nvCxnSpPr>
          <p:spPr>
            <a:xfrm>
              <a:off x="8147901" y="2988554"/>
              <a:ext cx="520028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0FE19E0B-D2E0-13E0-80CE-4E582D2D5B72}"/>
                </a:ext>
              </a:extLst>
            </p:cNvPr>
            <p:cNvGrpSpPr/>
            <p:nvPr/>
          </p:nvGrpSpPr>
          <p:grpSpPr>
            <a:xfrm>
              <a:off x="8457793" y="1522006"/>
              <a:ext cx="2062009" cy="523791"/>
              <a:chOff x="7993505" y="448576"/>
              <a:chExt cx="2062009" cy="523791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4FE3908-0EE9-7A19-6B55-78AE00CB0D66}"/>
                  </a:ext>
                </a:extLst>
              </p:cNvPr>
              <p:cNvSpPr txBox="1"/>
              <p:nvPr/>
            </p:nvSpPr>
            <p:spPr>
              <a:xfrm rot="18900000">
                <a:off x="7993505" y="603035"/>
                <a:ext cx="6944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err="1"/>
                  <a:t>siCon</a:t>
                </a:r>
                <a:endParaRPr lang="en-US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77F7542-518B-4245-B3CB-F98B65658673}"/>
                  </a:ext>
                </a:extLst>
              </p:cNvPr>
              <p:cNvSpPr txBox="1"/>
              <p:nvPr/>
            </p:nvSpPr>
            <p:spPr>
              <a:xfrm rot="18900000">
                <a:off x="8385057" y="448576"/>
                <a:ext cx="11528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siPGC1A-1</a:t>
                </a:r>
                <a:endParaRPr lang="en-US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926422B-8662-095B-0800-293A69865E1A}"/>
                  </a:ext>
                </a:extLst>
              </p:cNvPr>
              <p:cNvSpPr txBox="1"/>
              <p:nvPr/>
            </p:nvSpPr>
            <p:spPr>
              <a:xfrm rot="18900000">
                <a:off x="8902634" y="453960"/>
                <a:ext cx="11528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siPGC1A-2</a:t>
                </a:r>
                <a:endParaRPr lang="en-US" dirty="0"/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13A540C-A46D-803E-4973-B17AC864BD51}"/>
                </a:ext>
              </a:extLst>
            </p:cNvPr>
            <p:cNvSpPr txBox="1"/>
            <p:nvPr/>
          </p:nvSpPr>
          <p:spPr>
            <a:xfrm>
              <a:off x="10382835" y="5216825"/>
              <a:ext cx="23189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APDH 38kD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77ACB6B-8886-0067-4B1D-DC9DB07066AE}"/>
                </a:ext>
              </a:extLst>
            </p:cNvPr>
            <p:cNvSpPr txBox="1"/>
            <p:nvPr/>
          </p:nvSpPr>
          <p:spPr>
            <a:xfrm>
              <a:off x="5957132" y="965243"/>
              <a:ext cx="1992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</a:t>
              </a:r>
              <a:r>
                <a:rPr lang="en-US" baseline="30000" dirty="0"/>
                <a:t>st</a:t>
              </a:r>
              <a:r>
                <a:rPr lang="en-US" dirty="0"/>
                <a:t> transfectio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FAD9F7B-5E97-5FFB-05AD-7C0B0A782FD2}"/>
                </a:ext>
              </a:extLst>
            </p:cNvPr>
            <p:cNvSpPr txBox="1"/>
            <p:nvPr/>
          </p:nvSpPr>
          <p:spPr>
            <a:xfrm>
              <a:off x="8178581" y="970963"/>
              <a:ext cx="19922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</a:t>
              </a:r>
              <a:r>
                <a:rPr lang="en-US" baseline="30000" dirty="0"/>
                <a:t>nd</a:t>
              </a:r>
              <a:r>
                <a:rPr lang="en-US" dirty="0"/>
                <a:t>  transfection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CA591EA5-8B27-07EB-3652-20A3A7CA3B78}"/>
              </a:ext>
            </a:extLst>
          </p:cNvPr>
          <p:cNvSpPr/>
          <p:nvPr/>
        </p:nvSpPr>
        <p:spPr>
          <a:xfrm>
            <a:off x="5882453" y="2499105"/>
            <a:ext cx="1282507" cy="3393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3C0A430-13E5-87A3-F541-B3237F3F3251}"/>
              </a:ext>
            </a:extLst>
          </p:cNvPr>
          <p:cNvSpPr/>
          <p:nvPr/>
        </p:nvSpPr>
        <p:spPr>
          <a:xfrm>
            <a:off x="5882453" y="5135623"/>
            <a:ext cx="1282507" cy="3393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5544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2FDC16C-0AF5-637D-B574-A6A028AFD6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4887" y="1459504"/>
            <a:ext cx="3273836" cy="145097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50F5D5D-F960-9906-A652-B93AD02774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4887" y="2996146"/>
            <a:ext cx="3292125" cy="86570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DD64AB2-A0E6-EE43-E393-F8F2B418FD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82694" y="3947521"/>
            <a:ext cx="3298222" cy="135342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55F1989-1C94-28A6-0E97-15F1310A65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87914" y="1480842"/>
            <a:ext cx="3243353" cy="140829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593BB6D-E1B9-6D67-9105-558E3081B76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87913" y="3081814"/>
            <a:ext cx="3243353" cy="86570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F7D98BC-87D5-D181-8AB6-B2B526C9A2D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87913" y="4056968"/>
            <a:ext cx="3304318" cy="140220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9B37BC3-AE6F-81C1-DC75-5E0E4D42E5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25100" y="410902"/>
            <a:ext cx="3664014" cy="1377815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D960E279-E1D8-B0D0-45C4-51DCA4388FB2}"/>
              </a:ext>
            </a:extLst>
          </p:cNvPr>
          <p:cNvGrpSpPr/>
          <p:nvPr/>
        </p:nvGrpSpPr>
        <p:grpSpPr>
          <a:xfrm>
            <a:off x="7102888" y="916291"/>
            <a:ext cx="3547665" cy="543213"/>
            <a:chOff x="1725580" y="612232"/>
            <a:chExt cx="3547665" cy="543213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7005401-2B35-2FF3-81E5-F8BAAB1CFAFC}"/>
                </a:ext>
              </a:extLst>
            </p:cNvPr>
            <p:cNvSpPr txBox="1"/>
            <p:nvPr/>
          </p:nvSpPr>
          <p:spPr>
            <a:xfrm rot="18900000">
              <a:off x="1725580" y="732948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1</a:t>
              </a:r>
              <a:endParaRPr lang="en-US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4E6380D-6DAA-0A1E-A391-172195404B49}"/>
                </a:ext>
              </a:extLst>
            </p:cNvPr>
            <p:cNvSpPr txBox="1"/>
            <p:nvPr/>
          </p:nvSpPr>
          <p:spPr>
            <a:xfrm rot="18900000">
              <a:off x="1999267" y="612232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1</a:t>
              </a:r>
              <a:endParaRPr lang="en-US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C472150-7CAB-73B2-0D3D-339B474895D7}"/>
                </a:ext>
              </a:extLst>
            </p:cNvPr>
            <p:cNvSpPr txBox="1"/>
            <p:nvPr/>
          </p:nvSpPr>
          <p:spPr>
            <a:xfrm rot="18900000">
              <a:off x="2605596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2</a:t>
              </a:r>
              <a:endParaRPr lang="en-US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CF858ED-6ED8-B149-3BF1-5701360410AA}"/>
                </a:ext>
              </a:extLst>
            </p:cNvPr>
            <p:cNvSpPr txBox="1"/>
            <p:nvPr/>
          </p:nvSpPr>
          <p:spPr>
            <a:xfrm rot="18900000">
              <a:off x="2966040" y="612233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2</a:t>
              </a:r>
              <a:endParaRPr lang="en-US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49C68F1-0039-F464-4A93-667806CB382C}"/>
                </a:ext>
              </a:extLst>
            </p:cNvPr>
            <p:cNvSpPr txBox="1"/>
            <p:nvPr/>
          </p:nvSpPr>
          <p:spPr>
            <a:xfrm rot="18900000">
              <a:off x="3565461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3</a:t>
              </a:r>
              <a:endParaRPr 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E6ECED1-124D-33E9-3B25-2E994D64366D}"/>
                </a:ext>
              </a:extLst>
            </p:cNvPr>
            <p:cNvSpPr txBox="1"/>
            <p:nvPr/>
          </p:nvSpPr>
          <p:spPr>
            <a:xfrm rot="18900000">
              <a:off x="3932813" y="612234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3</a:t>
              </a:r>
              <a:endParaRPr lang="en-US" dirty="0"/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6432585D-B52E-D557-E0F0-8A571E2162D4}"/>
              </a:ext>
            </a:extLst>
          </p:cNvPr>
          <p:cNvSpPr txBox="1"/>
          <p:nvPr/>
        </p:nvSpPr>
        <p:spPr>
          <a:xfrm>
            <a:off x="4468723" y="2207765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SL1 </a:t>
            </a:r>
            <a:r>
              <a:rPr lang="en-US" altLang="zh-CN" dirty="0"/>
              <a:t>68kDa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1DB790D-3A42-4046-BA99-90F8B8712565}"/>
              </a:ext>
            </a:extLst>
          </p:cNvPr>
          <p:cNvSpPr txBox="1"/>
          <p:nvPr/>
        </p:nvSpPr>
        <p:spPr>
          <a:xfrm>
            <a:off x="10061520" y="2541146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PT2 </a:t>
            </a:r>
            <a:r>
              <a:rPr lang="en-US" altLang="zh-CN" dirty="0"/>
              <a:t>65kDa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4747C61-BB4F-CDC6-F34C-FDB640AFD96F}"/>
              </a:ext>
            </a:extLst>
          </p:cNvPr>
          <p:cNvSpPr txBox="1"/>
          <p:nvPr/>
        </p:nvSpPr>
        <p:spPr>
          <a:xfrm>
            <a:off x="10131266" y="3524139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LXR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50</a:t>
            </a:r>
            <a:r>
              <a:rPr lang="en-US" altLang="zh-CN" dirty="0"/>
              <a:t>kDa</a:t>
            </a:r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2EF305B-B485-85B7-8A8C-49249CA83E6B}"/>
              </a:ext>
            </a:extLst>
          </p:cNvPr>
          <p:cNvSpPr txBox="1"/>
          <p:nvPr/>
        </p:nvSpPr>
        <p:spPr>
          <a:xfrm>
            <a:off x="4568952" y="3364487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LXR</a:t>
            </a:r>
            <a:r>
              <a:rPr lang="en-US" dirty="0" err="1">
                <a:latin typeface="Symbol" panose="05050102010706020507" pitchFamily="18" charset="2"/>
              </a:rPr>
              <a:t>b</a:t>
            </a:r>
            <a:r>
              <a:rPr lang="en-US" dirty="0"/>
              <a:t> 51</a:t>
            </a:r>
            <a:r>
              <a:rPr lang="en-US" altLang="zh-CN" dirty="0"/>
              <a:t>kDa</a:t>
            </a:r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18466B1-4A6A-3545-C662-7366AF97B9EC}"/>
              </a:ext>
            </a:extLst>
          </p:cNvPr>
          <p:cNvSpPr txBox="1"/>
          <p:nvPr/>
        </p:nvSpPr>
        <p:spPr>
          <a:xfrm>
            <a:off x="4468722" y="4132680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FFC772A-3284-EF12-60E1-D4499701CF11}"/>
              </a:ext>
            </a:extLst>
          </p:cNvPr>
          <p:cNvSpPr txBox="1"/>
          <p:nvPr/>
        </p:nvSpPr>
        <p:spPr>
          <a:xfrm>
            <a:off x="10190035" y="425490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82266B7-292C-9838-5379-BF9519F8F3A0}"/>
              </a:ext>
            </a:extLst>
          </p:cNvPr>
          <p:cNvSpPr txBox="1"/>
          <p:nvPr/>
        </p:nvSpPr>
        <p:spPr>
          <a:xfrm>
            <a:off x="1976804" y="5267933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F8AFF7-2008-8835-B563-F011F95FC599}"/>
              </a:ext>
            </a:extLst>
          </p:cNvPr>
          <p:cNvSpPr txBox="1"/>
          <p:nvPr/>
        </p:nvSpPr>
        <p:spPr>
          <a:xfrm>
            <a:off x="6954400" y="5383131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B38C30C-824F-ABE4-ED09-5791DF7DA952}"/>
              </a:ext>
            </a:extLst>
          </p:cNvPr>
          <p:cNvSpPr/>
          <p:nvPr/>
        </p:nvSpPr>
        <p:spPr>
          <a:xfrm>
            <a:off x="2551814" y="4044074"/>
            <a:ext cx="850605" cy="35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A6FF45A-E87E-4426-7499-063C92CAB5E7}"/>
              </a:ext>
            </a:extLst>
          </p:cNvPr>
          <p:cNvSpPr/>
          <p:nvPr/>
        </p:nvSpPr>
        <p:spPr>
          <a:xfrm>
            <a:off x="7971158" y="2557218"/>
            <a:ext cx="850605" cy="35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4571EF9-2EAC-FCB0-25C4-5911F1316BB1}"/>
              </a:ext>
            </a:extLst>
          </p:cNvPr>
          <p:cNvSpPr/>
          <p:nvPr/>
        </p:nvSpPr>
        <p:spPr>
          <a:xfrm>
            <a:off x="7971158" y="3573984"/>
            <a:ext cx="850605" cy="35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A325BB6-9290-515D-3A86-248A565B1A69}"/>
              </a:ext>
            </a:extLst>
          </p:cNvPr>
          <p:cNvSpPr/>
          <p:nvPr/>
        </p:nvSpPr>
        <p:spPr>
          <a:xfrm>
            <a:off x="2558866" y="2456788"/>
            <a:ext cx="850605" cy="35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B11BC349-3260-5C18-993F-75EB2724869F}"/>
              </a:ext>
            </a:extLst>
          </p:cNvPr>
          <p:cNvSpPr/>
          <p:nvPr/>
        </p:nvSpPr>
        <p:spPr>
          <a:xfrm>
            <a:off x="2558866" y="3428999"/>
            <a:ext cx="850605" cy="353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83B55D3-4DA0-5462-FDC9-1F92AF4FA619}"/>
              </a:ext>
            </a:extLst>
          </p:cNvPr>
          <p:cNvSpPr txBox="1"/>
          <p:nvPr/>
        </p:nvSpPr>
        <p:spPr>
          <a:xfrm>
            <a:off x="1607170" y="204122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C</a:t>
            </a:r>
            <a:endParaRPr 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A28FC2C-4E3A-24E0-D0DE-A0CD2438A18A}"/>
              </a:ext>
            </a:extLst>
          </p:cNvPr>
          <p:cNvSpPr txBox="1"/>
          <p:nvPr/>
        </p:nvSpPr>
        <p:spPr>
          <a:xfrm>
            <a:off x="7046062" y="200691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C</a:t>
            </a:r>
            <a:endParaRPr lang="en-US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F3C2F8-7C41-D57E-2FD5-52F7C03C9234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37121761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10A204D-5256-D638-5DF8-B1350929DB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2572" y="2771781"/>
            <a:ext cx="3542083" cy="199356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3BC744E-2472-42BB-6210-31AC0F8275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4356" y="3546464"/>
            <a:ext cx="3572566" cy="148755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2AC2710-5704-AE94-122E-43E9A97C7A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84356" y="1388710"/>
            <a:ext cx="3548180" cy="199966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4DF2603-4F37-0675-5C91-B4C16551B06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5311" y="1649897"/>
            <a:ext cx="3511600" cy="1103472"/>
          </a:xfrm>
          <a:prstGeom prst="rect">
            <a:avLst/>
          </a:prstGeo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F9B14C4F-C485-E7C5-8E29-FB8273F46333}"/>
              </a:ext>
            </a:extLst>
          </p:cNvPr>
          <p:cNvGrpSpPr/>
          <p:nvPr/>
        </p:nvGrpSpPr>
        <p:grpSpPr>
          <a:xfrm>
            <a:off x="1505218" y="1096051"/>
            <a:ext cx="3547665" cy="543213"/>
            <a:chOff x="1725580" y="612232"/>
            <a:chExt cx="3547665" cy="543213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3FFBF04-616D-8AA8-A611-2DC988C9D68E}"/>
                </a:ext>
              </a:extLst>
            </p:cNvPr>
            <p:cNvSpPr txBox="1"/>
            <p:nvPr/>
          </p:nvSpPr>
          <p:spPr>
            <a:xfrm rot="18900000">
              <a:off x="1725580" y="732948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1</a:t>
              </a:r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BBF8E4D-08A4-2583-D35B-F0B9D4A87DF7}"/>
                </a:ext>
              </a:extLst>
            </p:cNvPr>
            <p:cNvSpPr txBox="1"/>
            <p:nvPr/>
          </p:nvSpPr>
          <p:spPr>
            <a:xfrm rot="18900000">
              <a:off x="1999267" y="612232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1</a:t>
              </a:r>
              <a:endParaRPr 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8A56BB1-BF63-8F17-C3DE-4490CC1C3AF4}"/>
                </a:ext>
              </a:extLst>
            </p:cNvPr>
            <p:cNvSpPr txBox="1"/>
            <p:nvPr/>
          </p:nvSpPr>
          <p:spPr>
            <a:xfrm rot="18900000">
              <a:off x="2605596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2</a:t>
              </a:r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C2EF3E3-3A11-8022-3268-279FF1BF8AA0}"/>
                </a:ext>
              </a:extLst>
            </p:cNvPr>
            <p:cNvSpPr txBox="1"/>
            <p:nvPr/>
          </p:nvSpPr>
          <p:spPr>
            <a:xfrm rot="18900000">
              <a:off x="2966040" y="612233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2</a:t>
              </a:r>
              <a:endParaRPr lang="en-US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7EB3271-8D73-1E80-D5E0-AAB6D786BBA3}"/>
                </a:ext>
              </a:extLst>
            </p:cNvPr>
            <p:cNvSpPr txBox="1"/>
            <p:nvPr/>
          </p:nvSpPr>
          <p:spPr>
            <a:xfrm rot="18900000">
              <a:off x="3565461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3</a:t>
              </a:r>
              <a:endParaRPr lang="en-US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A0E78CA-2D30-D128-7F64-9E8F37F305CE}"/>
                </a:ext>
              </a:extLst>
            </p:cNvPr>
            <p:cNvSpPr txBox="1"/>
            <p:nvPr/>
          </p:nvSpPr>
          <p:spPr>
            <a:xfrm rot="18900000">
              <a:off x="3932813" y="612234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3</a:t>
              </a:r>
              <a:endParaRPr lang="en-US" dirty="0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E2ED043-CB79-93E1-68E7-CFC8BEC80A47}"/>
              </a:ext>
            </a:extLst>
          </p:cNvPr>
          <p:cNvGrpSpPr/>
          <p:nvPr/>
        </p:nvGrpSpPr>
        <p:grpSpPr>
          <a:xfrm>
            <a:off x="7459646" y="893116"/>
            <a:ext cx="3547665" cy="543213"/>
            <a:chOff x="1725580" y="612232"/>
            <a:chExt cx="3547665" cy="543213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926CF1D-E78B-A079-3A98-99F38B7A6E8E}"/>
                </a:ext>
              </a:extLst>
            </p:cNvPr>
            <p:cNvSpPr txBox="1"/>
            <p:nvPr/>
          </p:nvSpPr>
          <p:spPr>
            <a:xfrm rot="18900000">
              <a:off x="1725580" y="732948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1</a:t>
              </a:r>
              <a:endParaRPr lang="en-US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5104407-E04F-A195-1494-0674C131AD25}"/>
                </a:ext>
              </a:extLst>
            </p:cNvPr>
            <p:cNvSpPr txBox="1"/>
            <p:nvPr/>
          </p:nvSpPr>
          <p:spPr>
            <a:xfrm rot="18900000">
              <a:off x="1999267" y="612232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1</a:t>
              </a:r>
              <a:endParaRPr 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667C4A8-A0F0-4F18-43D1-0962967E47E4}"/>
                </a:ext>
              </a:extLst>
            </p:cNvPr>
            <p:cNvSpPr txBox="1"/>
            <p:nvPr/>
          </p:nvSpPr>
          <p:spPr>
            <a:xfrm rot="18900000">
              <a:off x="2605596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2</a:t>
              </a:r>
              <a:endParaRPr 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C8B14E-0183-E72B-F8FA-A95B229BE060}"/>
                </a:ext>
              </a:extLst>
            </p:cNvPr>
            <p:cNvSpPr txBox="1"/>
            <p:nvPr/>
          </p:nvSpPr>
          <p:spPr>
            <a:xfrm rot="18900000">
              <a:off x="2966040" y="612233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2</a:t>
              </a:r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3E6A25C-3EE3-6765-AF05-E6F2150A16CF}"/>
                </a:ext>
              </a:extLst>
            </p:cNvPr>
            <p:cNvSpPr txBox="1"/>
            <p:nvPr/>
          </p:nvSpPr>
          <p:spPr>
            <a:xfrm rot="18900000">
              <a:off x="3565461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3</a:t>
              </a:r>
              <a:endParaRPr lang="en-US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99DEE76-A966-D6BD-E3B9-8FCDDC03643E}"/>
                </a:ext>
              </a:extLst>
            </p:cNvPr>
            <p:cNvSpPr txBox="1"/>
            <p:nvPr/>
          </p:nvSpPr>
          <p:spPr>
            <a:xfrm rot="18900000">
              <a:off x="3932813" y="612234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3</a:t>
              </a:r>
              <a:endParaRPr lang="en-US" dirty="0"/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700106AC-52FE-3698-B1C1-274BEF82CD6F}"/>
              </a:ext>
            </a:extLst>
          </p:cNvPr>
          <p:cNvSpPr txBox="1"/>
          <p:nvPr/>
        </p:nvSpPr>
        <p:spPr>
          <a:xfrm>
            <a:off x="4841128" y="2134624"/>
            <a:ext cx="1485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PT1A  88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9A8F6AB-0DA3-E976-8AEA-CDA38D9266A2}"/>
              </a:ext>
            </a:extLst>
          </p:cNvPr>
          <p:cNvSpPr txBox="1"/>
          <p:nvPr/>
        </p:nvSpPr>
        <p:spPr>
          <a:xfrm>
            <a:off x="4769820" y="3262827"/>
            <a:ext cx="1609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ADM  43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DF3BFBB-FD8B-E54C-2E2F-CBE4BD70ED3E}"/>
              </a:ext>
            </a:extLst>
          </p:cNvPr>
          <p:cNvSpPr txBox="1"/>
          <p:nvPr/>
        </p:nvSpPr>
        <p:spPr>
          <a:xfrm>
            <a:off x="10432536" y="2934126"/>
            <a:ext cx="1950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PAR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 52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B1AA093-30D7-3C5C-2883-974375F1E1EF}"/>
              </a:ext>
            </a:extLst>
          </p:cNvPr>
          <p:cNvSpPr txBox="1"/>
          <p:nvPr/>
        </p:nvSpPr>
        <p:spPr>
          <a:xfrm>
            <a:off x="10432536" y="4000471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CCE4858-4A5F-058A-CE95-A318FB4E29EC}"/>
              </a:ext>
            </a:extLst>
          </p:cNvPr>
          <p:cNvSpPr txBox="1"/>
          <p:nvPr/>
        </p:nvSpPr>
        <p:spPr>
          <a:xfrm>
            <a:off x="2118722" y="4783758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0581B91-A5CA-6FF9-28CE-9CEA3A59E2A9}"/>
              </a:ext>
            </a:extLst>
          </p:cNvPr>
          <p:cNvSpPr txBox="1"/>
          <p:nvPr/>
        </p:nvSpPr>
        <p:spPr>
          <a:xfrm>
            <a:off x="7528370" y="5092357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736F42E-B967-D512-C656-311010647166}"/>
              </a:ext>
            </a:extLst>
          </p:cNvPr>
          <p:cNvSpPr/>
          <p:nvPr/>
        </p:nvSpPr>
        <p:spPr>
          <a:xfrm>
            <a:off x="2385020" y="3344420"/>
            <a:ext cx="881257" cy="315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2B39A5D-C69E-14B8-9335-E5D45CDBF043}"/>
              </a:ext>
            </a:extLst>
          </p:cNvPr>
          <p:cNvSpPr/>
          <p:nvPr/>
        </p:nvSpPr>
        <p:spPr>
          <a:xfrm>
            <a:off x="2385020" y="2230993"/>
            <a:ext cx="881257" cy="315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CDB17A7-744E-8746-C0E5-17E15987518F}"/>
              </a:ext>
            </a:extLst>
          </p:cNvPr>
          <p:cNvSpPr/>
          <p:nvPr/>
        </p:nvSpPr>
        <p:spPr>
          <a:xfrm>
            <a:off x="8384913" y="3044542"/>
            <a:ext cx="881257" cy="315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983B56C9-219E-5396-9527-369C4C14B709}"/>
              </a:ext>
            </a:extLst>
          </p:cNvPr>
          <p:cNvCxnSpPr/>
          <p:nvPr/>
        </p:nvCxnSpPr>
        <p:spPr>
          <a:xfrm>
            <a:off x="1185128" y="3453833"/>
            <a:ext cx="47274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04F3725-2774-9F95-51E4-ED73A4176909}"/>
              </a:ext>
            </a:extLst>
          </p:cNvPr>
          <p:cNvSpPr txBox="1"/>
          <p:nvPr/>
        </p:nvSpPr>
        <p:spPr>
          <a:xfrm>
            <a:off x="1606467" y="318667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C</a:t>
            </a:r>
            <a:endParaRPr 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E9562EC-DE24-4854-DA5E-EA090D0CC7E1}"/>
              </a:ext>
            </a:extLst>
          </p:cNvPr>
          <p:cNvSpPr txBox="1"/>
          <p:nvPr/>
        </p:nvSpPr>
        <p:spPr>
          <a:xfrm>
            <a:off x="7220319" y="203710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C</a:t>
            </a:r>
            <a:endParaRPr lang="en-US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D900AC2-D563-EF3D-AF8C-B5A472145C47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106937161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1C79DA2-88B8-FB98-F780-ABBF0AAFF3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9350" y="1829904"/>
            <a:ext cx="3328704" cy="68890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289C45-F177-F4FD-888A-98BE928317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9350" y="2660837"/>
            <a:ext cx="3328704" cy="15363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55F18FB-92C8-736C-98AE-37E6327D99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24388" y="1759794"/>
            <a:ext cx="3243353" cy="82912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69FAFCD-F4B3-452F-19F8-AD23CDFA61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21990" y="2686467"/>
            <a:ext cx="3243353" cy="1560711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30CDB51E-64D5-FB7F-6790-9A36B24AA579}"/>
              </a:ext>
            </a:extLst>
          </p:cNvPr>
          <p:cNvGrpSpPr/>
          <p:nvPr/>
        </p:nvGrpSpPr>
        <p:grpSpPr>
          <a:xfrm>
            <a:off x="1648047" y="1215678"/>
            <a:ext cx="3547665" cy="543213"/>
            <a:chOff x="1725580" y="612232"/>
            <a:chExt cx="3547665" cy="54321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9E7B30A-5F3D-D52F-E031-40DB4FDD06CE}"/>
                </a:ext>
              </a:extLst>
            </p:cNvPr>
            <p:cNvSpPr txBox="1"/>
            <p:nvPr/>
          </p:nvSpPr>
          <p:spPr>
            <a:xfrm rot="18900000">
              <a:off x="1725580" y="732948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1</a:t>
              </a:r>
              <a:endParaRPr 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D1BB79D-C43A-FD2B-F918-BACBED5C43A1}"/>
                </a:ext>
              </a:extLst>
            </p:cNvPr>
            <p:cNvSpPr txBox="1"/>
            <p:nvPr/>
          </p:nvSpPr>
          <p:spPr>
            <a:xfrm rot="18900000">
              <a:off x="1999267" y="612232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1</a:t>
              </a:r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4E09AAB-A476-ACDB-0B1E-5B8267857574}"/>
                </a:ext>
              </a:extLst>
            </p:cNvPr>
            <p:cNvSpPr txBox="1"/>
            <p:nvPr/>
          </p:nvSpPr>
          <p:spPr>
            <a:xfrm rot="18900000">
              <a:off x="2605596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2</a:t>
              </a:r>
              <a:endParaRPr lang="en-US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EDA08FF-3B49-899F-57EA-7440C775FA51}"/>
                </a:ext>
              </a:extLst>
            </p:cNvPr>
            <p:cNvSpPr txBox="1"/>
            <p:nvPr/>
          </p:nvSpPr>
          <p:spPr>
            <a:xfrm rot="18900000">
              <a:off x="2966040" y="612233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2</a:t>
              </a:r>
              <a:endParaRPr lang="en-US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65EAA5B-690A-79EE-4100-8B76CA882559}"/>
                </a:ext>
              </a:extLst>
            </p:cNvPr>
            <p:cNvSpPr txBox="1"/>
            <p:nvPr/>
          </p:nvSpPr>
          <p:spPr>
            <a:xfrm rot="18900000">
              <a:off x="3565461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3</a:t>
              </a:r>
              <a:endParaRPr lang="en-US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8D8B29C-31B6-232B-062E-7C29B16666C1}"/>
                </a:ext>
              </a:extLst>
            </p:cNvPr>
            <p:cNvSpPr txBox="1"/>
            <p:nvPr/>
          </p:nvSpPr>
          <p:spPr>
            <a:xfrm rot="18900000">
              <a:off x="3932813" y="612234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3</a:t>
              </a:r>
              <a:endParaRPr lang="en-US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D27295D-0220-6435-82B1-4DA564EC862D}"/>
              </a:ext>
            </a:extLst>
          </p:cNvPr>
          <p:cNvGrpSpPr/>
          <p:nvPr/>
        </p:nvGrpSpPr>
        <p:grpSpPr>
          <a:xfrm>
            <a:off x="6507126" y="1156858"/>
            <a:ext cx="3547665" cy="543213"/>
            <a:chOff x="1725580" y="612232"/>
            <a:chExt cx="3547665" cy="543213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40E10BD-5F39-4DBE-D0F8-BA0715CFB3B4}"/>
                </a:ext>
              </a:extLst>
            </p:cNvPr>
            <p:cNvSpPr txBox="1"/>
            <p:nvPr/>
          </p:nvSpPr>
          <p:spPr>
            <a:xfrm rot="18900000">
              <a:off x="1725580" y="732948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1</a:t>
              </a:r>
              <a:endParaRPr 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2D4A55A-5E4A-C928-EF47-4CCB95361F61}"/>
                </a:ext>
              </a:extLst>
            </p:cNvPr>
            <p:cNvSpPr txBox="1"/>
            <p:nvPr/>
          </p:nvSpPr>
          <p:spPr>
            <a:xfrm rot="18900000">
              <a:off x="1999267" y="612232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1</a:t>
              </a:r>
              <a:endParaRPr 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6AA76B1-78B7-DB3A-994D-EFBB3C364710}"/>
                </a:ext>
              </a:extLst>
            </p:cNvPr>
            <p:cNvSpPr txBox="1"/>
            <p:nvPr/>
          </p:nvSpPr>
          <p:spPr>
            <a:xfrm rot="18900000">
              <a:off x="2605596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2</a:t>
              </a:r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05D63F0-4915-71F5-CC3A-8DAC3D6BB20E}"/>
                </a:ext>
              </a:extLst>
            </p:cNvPr>
            <p:cNvSpPr txBox="1"/>
            <p:nvPr/>
          </p:nvSpPr>
          <p:spPr>
            <a:xfrm rot="18900000">
              <a:off x="2966040" y="612233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2</a:t>
              </a:r>
              <a:endParaRPr lang="en-US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589FCB7-9228-BC46-2316-8825017736B7}"/>
                </a:ext>
              </a:extLst>
            </p:cNvPr>
            <p:cNvSpPr txBox="1"/>
            <p:nvPr/>
          </p:nvSpPr>
          <p:spPr>
            <a:xfrm rot="18900000">
              <a:off x="3565461" y="786113"/>
              <a:ext cx="8114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Con3</a:t>
              </a:r>
              <a:endParaRPr lang="en-US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CADD404-8395-B454-F670-31A30632FEB6}"/>
                </a:ext>
              </a:extLst>
            </p:cNvPr>
            <p:cNvSpPr txBox="1"/>
            <p:nvPr/>
          </p:nvSpPr>
          <p:spPr>
            <a:xfrm rot="18900000">
              <a:off x="3932813" y="612234"/>
              <a:ext cx="1340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siPGC1A-1-3</a:t>
              </a:r>
              <a:endParaRPr lang="en-US" dirty="0"/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D35A160C-F83B-7DBC-8FF8-B716DC298E43}"/>
              </a:ext>
            </a:extLst>
          </p:cNvPr>
          <p:cNvSpPr txBox="1"/>
          <p:nvPr/>
        </p:nvSpPr>
        <p:spPr>
          <a:xfrm>
            <a:off x="4550445" y="1707827"/>
            <a:ext cx="1454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PAR</a:t>
            </a:r>
            <a:r>
              <a:rPr lang="en-US" dirty="0" err="1">
                <a:latin typeface="Symbol" panose="05050102010706020507" pitchFamily="18" charset="2"/>
              </a:rPr>
              <a:t>g</a:t>
            </a:r>
            <a:r>
              <a:rPr lang="en-US" dirty="0"/>
              <a:t>  58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C0C1355-9BA2-784A-DCAE-CEFD67E433C5}"/>
              </a:ext>
            </a:extLst>
          </p:cNvPr>
          <p:cNvSpPr txBox="1"/>
          <p:nvPr/>
        </p:nvSpPr>
        <p:spPr>
          <a:xfrm>
            <a:off x="9587022" y="1943845"/>
            <a:ext cx="16937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PAR</a:t>
            </a:r>
            <a:r>
              <a:rPr lang="en-US" dirty="0" err="1">
                <a:latin typeface="Symbol" panose="05050102010706020507" pitchFamily="18" charset="2"/>
              </a:rPr>
              <a:t>b</a:t>
            </a:r>
            <a:r>
              <a:rPr lang="en-US" dirty="0"/>
              <a:t>/</a:t>
            </a:r>
            <a:r>
              <a:rPr lang="en-US" dirty="0">
                <a:latin typeface="Symbol" panose="05050102010706020507" pitchFamily="18" charset="2"/>
              </a:rPr>
              <a:t>d</a:t>
            </a:r>
            <a:r>
              <a:rPr lang="en-US" dirty="0"/>
              <a:t>  54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7BF83E3-C16B-299D-DE1C-0B8E174E9E17}"/>
              </a:ext>
            </a:extLst>
          </p:cNvPr>
          <p:cNvSpPr txBox="1"/>
          <p:nvPr/>
        </p:nvSpPr>
        <p:spPr>
          <a:xfrm>
            <a:off x="4488622" y="298913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C838C5B-EA88-9B8C-7A2F-BF552F39482C}"/>
              </a:ext>
            </a:extLst>
          </p:cNvPr>
          <p:cNvSpPr txBox="1"/>
          <p:nvPr/>
        </p:nvSpPr>
        <p:spPr>
          <a:xfrm>
            <a:off x="9587022" y="3062138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65136E9-2128-7C4A-3412-F3468BB1C300}"/>
              </a:ext>
            </a:extLst>
          </p:cNvPr>
          <p:cNvSpPr txBox="1"/>
          <p:nvPr/>
        </p:nvSpPr>
        <p:spPr>
          <a:xfrm>
            <a:off x="1894278" y="4247178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B5DA40E-7545-655C-7160-B26252C043B8}"/>
              </a:ext>
            </a:extLst>
          </p:cNvPr>
          <p:cNvSpPr txBox="1"/>
          <p:nvPr/>
        </p:nvSpPr>
        <p:spPr>
          <a:xfrm>
            <a:off x="7038751" y="4360158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4D7DC68-B8C5-038A-C3C2-C5F2855E03F5}"/>
              </a:ext>
            </a:extLst>
          </p:cNvPr>
          <p:cNvSpPr/>
          <p:nvPr/>
        </p:nvSpPr>
        <p:spPr>
          <a:xfrm>
            <a:off x="2571612" y="1798907"/>
            <a:ext cx="90457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37E7305-F9E7-6FAA-7C37-6C8796F687F8}"/>
              </a:ext>
            </a:extLst>
          </p:cNvPr>
          <p:cNvSpPr/>
          <p:nvPr/>
        </p:nvSpPr>
        <p:spPr>
          <a:xfrm>
            <a:off x="7388159" y="1937132"/>
            <a:ext cx="90457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21BDC9F-41F3-29A9-9BEE-194945926078}"/>
              </a:ext>
            </a:extLst>
          </p:cNvPr>
          <p:cNvSpPr txBox="1"/>
          <p:nvPr/>
        </p:nvSpPr>
        <p:spPr>
          <a:xfrm>
            <a:off x="1418675" y="395724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C</a:t>
            </a:r>
            <a:endParaRPr 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4A6DA17-9592-45C4-E4D2-28AEDBC9EFB7}"/>
              </a:ext>
            </a:extLst>
          </p:cNvPr>
          <p:cNvSpPr txBox="1"/>
          <p:nvPr/>
        </p:nvSpPr>
        <p:spPr>
          <a:xfrm>
            <a:off x="6450300" y="342073"/>
            <a:ext cx="3210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</a:t>
            </a:r>
            <a:r>
              <a:rPr lang="en-US" altLang="zh-CN" b="1" dirty="0"/>
              <a:t>upplementary </a:t>
            </a:r>
            <a:r>
              <a:rPr lang="en-US" b="1" dirty="0"/>
              <a:t>F</a:t>
            </a:r>
            <a:r>
              <a:rPr lang="en-US" altLang="zh-CN" b="1" dirty="0"/>
              <a:t>igure 2C</a:t>
            </a:r>
            <a:endParaRPr lang="en-US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61160B1-8652-541B-469C-B9EE25A96062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211699148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4EFCBD1-E251-9BE4-A8C9-13F918780A50}"/>
              </a:ext>
            </a:extLst>
          </p:cNvPr>
          <p:cNvGrpSpPr/>
          <p:nvPr/>
        </p:nvGrpSpPr>
        <p:grpSpPr>
          <a:xfrm>
            <a:off x="1363593" y="1185739"/>
            <a:ext cx="8824228" cy="4866817"/>
            <a:chOff x="1395491" y="1153842"/>
            <a:chExt cx="8824228" cy="486681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AC7F1ED-34F1-2D92-C221-A7B8E2A64AF2}"/>
                </a:ext>
              </a:extLst>
            </p:cNvPr>
            <p:cNvSpPr txBox="1"/>
            <p:nvPr/>
          </p:nvSpPr>
          <p:spPr>
            <a:xfrm>
              <a:off x="2022764" y="5651327"/>
              <a:ext cx="3264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% Tris-glycine gel</a:t>
              </a:r>
              <a:endParaRPr lang="en-US" dirty="0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132E0FE-B31A-947E-3E98-2616759A83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95491" y="1785024"/>
              <a:ext cx="3212870" cy="191431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47C79E4-042F-C96D-5680-C34F495259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95491" y="3840497"/>
              <a:ext cx="3212870" cy="1548518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878B8F28-D71B-7F74-0016-7764FE2B908C}"/>
                </a:ext>
              </a:extLst>
            </p:cNvPr>
            <p:cNvGrpSpPr/>
            <p:nvPr/>
          </p:nvGrpSpPr>
          <p:grpSpPr>
            <a:xfrm>
              <a:off x="1881743" y="1175107"/>
              <a:ext cx="3561704" cy="468754"/>
              <a:chOff x="970839" y="418953"/>
              <a:chExt cx="3561704" cy="468754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3E8AFC3-AFF2-4119-3C8D-E80C40A88B4A}"/>
                  </a:ext>
                </a:extLst>
              </p:cNvPr>
              <p:cNvSpPr txBox="1"/>
              <p:nvPr/>
            </p:nvSpPr>
            <p:spPr>
              <a:xfrm rot="18900000">
                <a:off x="970839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1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C37D0CBA-2CD1-6A3E-6233-985175587D54}"/>
                  </a:ext>
                </a:extLst>
              </p:cNvPr>
              <p:cNvSpPr txBox="1"/>
              <p:nvPr/>
            </p:nvSpPr>
            <p:spPr>
              <a:xfrm rot="18900000">
                <a:off x="1331621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788C9BF-5564-E432-F7B3-37D40B9032C5}"/>
                  </a:ext>
                </a:extLst>
              </p:cNvPr>
              <p:cNvSpPr txBox="1"/>
              <p:nvPr/>
            </p:nvSpPr>
            <p:spPr>
              <a:xfrm rot="18900000">
                <a:off x="1873168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2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EEAE253-BCDE-F4CE-6FDF-1C524D0357EC}"/>
                  </a:ext>
                </a:extLst>
              </p:cNvPr>
              <p:cNvSpPr txBox="1"/>
              <p:nvPr/>
            </p:nvSpPr>
            <p:spPr>
              <a:xfrm rot="18900000">
                <a:off x="2328496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2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B4644BE-B5B7-9C50-C652-742B0C013BF5}"/>
                  </a:ext>
                </a:extLst>
              </p:cNvPr>
              <p:cNvSpPr txBox="1"/>
              <p:nvPr/>
            </p:nvSpPr>
            <p:spPr>
              <a:xfrm rot="18900000">
                <a:off x="2810926" y="516886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3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1B4AE89-FA9F-5730-6019-A1C85EEEC182}"/>
                  </a:ext>
                </a:extLst>
              </p:cNvPr>
              <p:cNvSpPr txBox="1"/>
              <p:nvPr/>
            </p:nvSpPr>
            <p:spPr>
              <a:xfrm rot="18900000">
                <a:off x="3207885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3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7BF91E17-F2F7-2E24-CCF9-EBFAABD5DB5C}"/>
                </a:ext>
              </a:extLst>
            </p:cNvPr>
            <p:cNvGrpSpPr/>
            <p:nvPr/>
          </p:nvGrpSpPr>
          <p:grpSpPr>
            <a:xfrm>
              <a:off x="5621686" y="1153842"/>
              <a:ext cx="3923910" cy="4138524"/>
              <a:chOff x="6398942" y="1175107"/>
              <a:chExt cx="3923910" cy="4138524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961AAC08-54D8-E99F-E8AA-78AD6A8283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770780" y="3898438"/>
                <a:ext cx="3212872" cy="1415193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72DC337A-C08E-5DB2-BA14-9A36C6519A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770780" y="1749388"/>
                <a:ext cx="3212870" cy="2091109"/>
              </a:xfrm>
              <a:prstGeom prst="rect">
                <a:avLst/>
              </a:prstGeom>
            </p:spPr>
          </p:pic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2C1882E4-39EE-65B4-D66E-42CBD567B7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98942" y="2871977"/>
                <a:ext cx="520568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28E98CE5-25FD-B4E1-4BCC-C5F597F32093}"/>
                  </a:ext>
                </a:extLst>
              </p:cNvPr>
              <p:cNvGrpSpPr/>
              <p:nvPr/>
            </p:nvGrpSpPr>
            <p:grpSpPr>
              <a:xfrm>
                <a:off x="6761148" y="1175107"/>
                <a:ext cx="3561704" cy="468754"/>
                <a:chOff x="970839" y="418953"/>
                <a:chExt cx="3561704" cy="468754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E99B6709-1A2D-0CFC-D468-27A9816C56F9}"/>
                    </a:ext>
                  </a:extLst>
                </p:cNvPr>
                <p:cNvSpPr txBox="1"/>
                <p:nvPr/>
              </p:nvSpPr>
              <p:spPr>
                <a:xfrm rot="18900000">
                  <a:off x="970839" y="518375"/>
                  <a:ext cx="104765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Control 1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AFAFFA05-7CFF-F1F7-1557-FA670FC4A3BD}"/>
                    </a:ext>
                  </a:extLst>
                </p:cNvPr>
                <p:cNvSpPr txBox="1"/>
                <p:nvPr/>
              </p:nvSpPr>
              <p:spPr>
                <a:xfrm rot="18900000">
                  <a:off x="1331621" y="418953"/>
                  <a:ext cx="132465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PGC1A-KO 1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696C0DB-18A6-DC16-298D-F79DCA4D5C8B}"/>
                    </a:ext>
                  </a:extLst>
                </p:cNvPr>
                <p:cNvSpPr txBox="1"/>
                <p:nvPr/>
              </p:nvSpPr>
              <p:spPr>
                <a:xfrm rot="18900000">
                  <a:off x="1873168" y="518375"/>
                  <a:ext cx="104765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Control 2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C57F92AE-9258-8E11-F40E-29DD9CA63191}"/>
                    </a:ext>
                  </a:extLst>
                </p:cNvPr>
                <p:cNvSpPr txBox="1"/>
                <p:nvPr/>
              </p:nvSpPr>
              <p:spPr>
                <a:xfrm rot="18900000">
                  <a:off x="2328496" y="418953"/>
                  <a:ext cx="132465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PGC1A-KO 2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94F08B71-A527-04A7-2EB0-2C19CD229D89}"/>
                    </a:ext>
                  </a:extLst>
                </p:cNvPr>
                <p:cNvSpPr txBox="1"/>
                <p:nvPr/>
              </p:nvSpPr>
              <p:spPr>
                <a:xfrm rot="18900000">
                  <a:off x="2810926" y="516886"/>
                  <a:ext cx="104765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Control 3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FA36E31B-5FC3-514D-30E2-70C1ECA8B566}"/>
                    </a:ext>
                  </a:extLst>
                </p:cNvPr>
                <p:cNvSpPr txBox="1"/>
                <p:nvPr/>
              </p:nvSpPr>
              <p:spPr>
                <a:xfrm rot="18900000">
                  <a:off x="3207885" y="418953"/>
                  <a:ext cx="132465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PGC1A-KO 3</a:t>
                  </a:r>
                </a:p>
              </p:txBody>
            </p:sp>
          </p:grp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1528D44-6801-CC74-D248-8DD6382E5C73}"/>
                </a:ext>
              </a:extLst>
            </p:cNvPr>
            <p:cNvSpPr txBox="1"/>
            <p:nvPr/>
          </p:nvSpPr>
          <p:spPr>
            <a:xfrm>
              <a:off x="4569196" y="2714927"/>
              <a:ext cx="10133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97kD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1531045-C572-A9D4-B81B-41BD8248C27B}"/>
                </a:ext>
              </a:extLst>
            </p:cNvPr>
            <p:cNvSpPr txBox="1"/>
            <p:nvPr/>
          </p:nvSpPr>
          <p:spPr>
            <a:xfrm>
              <a:off x="9206394" y="2666046"/>
              <a:ext cx="10133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97kD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51A9549-F04A-C6B9-A071-C34D5A808DE9}"/>
                </a:ext>
              </a:extLst>
            </p:cNvPr>
            <p:cNvSpPr txBox="1"/>
            <p:nvPr/>
          </p:nvSpPr>
          <p:spPr>
            <a:xfrm>
              <a:off x="4569196" y="4462580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8kD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41B2016-5AE0-4D8A-E08D-026ADA15652F}"/>
                </a:ext>
              </a:extLst>
            </p:cNvPr>
            <p:cNvSpPr txBox="1"/>
            <p:nvPr/>
          </p:nvSpPr>
          <p:spPr>
            <a:xfrm>
              <a:off x="9128068" y="4547854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8kDa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731CD004-AC49-94BE-94C6-91373F46FFC0}"/>
              </a:ext>
            </a:extLst>
          </p:cNvPr>
          <p:cNvSpPr txBox="1"/>
          <p:nvPr/>
        </p:nvSpPr>
        <p:spPr>
          <a:xfrm>
            <a:off x="6620355" y="5683224"/>
            <a:ext cx="326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% Tris-glycine gel</a:t>
            </a:r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141373C-8F02-4E78-CFAE-8DA3D12F8DC0}"/>
              </a:ext>
            </a:extLst>
          </p:cNvPr>
          <p:cNvSpPr/>
          <p:nvPr/>
        </p:nvSpPr>
        <p:spPr>
          <a:xfrm>
            <a:off x="2775021" y="2697943"/>
            <a:ext cx="788117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25C12D52-7373-3CF6-0892-F1479905473B}"/>
              </a:ext>
            </a:extLst>
          </p:cNvPr>
          <p:cNvSpPr/>
          <p:nvPr/>
        </p:nvSpPr>
        <p:spPr>
          <a:xfrm>
            <a:off x="6881230" y="2719210"/>
            <a:ext cx="788117" cy="259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F9DC6019-1346-8B88-6192-9033062B213E}"/>
              </a:ext>
            </a:extLst>
          </p:cNvPr>
          <p:cNvSpPr/>
          <p:nvPr/>
        </p:nvSpPr>
        <p:spPr>
          <a:xfrm>
            <a:off x="2775021" y="4550646"/>
            <a:ext cx="788117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1170C066-C88E-EF1C-3DA0-490F4A773961}"/>
              </a:ext>
            </a:extLst>
          </p:cNvPr>
          <p:cNvSpPr/>
          <p:nvPr/>
        </p:nvSpPr>
        <p:spPr>
          <a:xfrm>
            <a:off x="6897572" y="4550646"/>
            <a:ext cx="788117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CE9100A-631C-AB91-8560-6DB44569EE13}"/>
              </a:ext>
            </a:extLst>
          </p:cNvPr>
          <p:cNvSpPr txBox="1"/>
          <p:nvPr/>
        </p:nvSpPr>
        <p:spPr>
          <a:xfrm>
            <a:off x="421217" y="6262707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F4A7F21-A819-4CC7-736F-A246BB13ED95}"/>
              </a:ext>
            </a:extLst>
          </p:cNvPr>
          <p:cNvSpPr txBox="1"/>
          <p:nvPr/>
        </p:nvSpPr>
        <p:spPr>
          <a:xfrm>
            <a:off x="4979239" y="271001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H-I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062337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86ED683-92F6-A0CC-519B-1C70F7534FA3}"/>
              </a:ext>
            </a:extLst>
          </p:cNvPr>
          <p:cNvGrpSpPr/>
          <p:nvPr/>
        </p:nvGrpSpPr>
        <p:grpSpPr>
          <a:xfrm>
            <a:off x="862674" y="942206"/>
            <a:ext cx="10265016" cy="4732983"/>
            <a:chOff x="862674" y="942206"/>
            <a:chExt cx="10265016" cy="473298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40D5DC4-A5F6-3510-1426-AD7E1C9A1538}"/>
                </a:ext>
              </a:extLst>
            </p:cNvPr>
            <p:cNvSpPr txBox="1"/>
            <p:nvPr/>
          </p:nvSpPr>
          <p:spPr>
            <a:xfrm>
              <a:off x="1577367" y="5201592"/>
              <a:ext cx="3264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% Tris-glycine gel</a:t>
              </a:r>
              <a:endParaRPr lang="en-US" dirty="0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9D885CF-F18A-678D-369D-FF1A7A3443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77916" y="1483896"/>
              <a:ext cx="3450635" cy="158509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C762F0A-8A66-2207-4762-923E3FE084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62674" y="3187584"/>
              <a:ext cx="3481118" cy="1822862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1794621-A6F7-CE17-30DE-CBA4F39D9A0F}"/>
                </a:ext>
              </a:extLst>
            </p:cNvPr>
            <p:cNvGrpSpPr/>
            <p:nvPr/>
          </p:nvGrpSpPr>
          <p:grpSpPr>
            <a:xfrm>
              <a:off x="1558673" y="950277"/>
              <a:ext cx="3561704" cy="468754"/>
              <a:chOff x="970839" y="418953"/>
              <a:chExt cx="3561704" cy="468754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AAF8D8F-DB81-C923-B2DB-AB9DA2C79595}"/>
                  </a:ext>
                </a:extLst>
              </p:cNvPr>
              <p:cNvSpPr txBox="1"/>
              <p:nvPr/>
            </p:nvSpPr>
            <p:spPr>
              <a:xfrm rot="18900000">
                <a:off x="970839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1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F8AB9FC-054C-ECFD-FAE8-4189E91F2664}"/>
                  </a:ext>
                </a:extLst>
              </p:cNvPr>
              <p:cNvSpPr txBox="1"/>
              <p:nvPr/>
            </p:nvSpPr>
            <p:spPr>
              <a:xfrm rot="18900000">
                <a:off x="1331621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8F214FA-D99A-D367-9A4D-2EE23DCD4303}"/>
                  </a:ext>
                </a:extLst>
              </p:cNvPr>
              <p:cNvSpPr txBox="1"/>
              <p:nvPr/>
            </p:nvSpPr>
            <p:spPr>
              <a:xfrm rot="18900000">
                <a:off x="1873168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2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231029CA-34A8-203F-976D-15F2096D88BE}"/>
                  </a:ext>
                </a:extLst>
              </p:cNvPr>
              <p:cNvSpPr txBox="1"/>
              <p:nvPr/>
            </p:nvSpPr>
            <p:spPr>
              <a:xfrm rot="18900000">
                <a:off x="2328496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2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505B36A-D125-1092-7FC8-566D6A46C7A9}"/>
                  </a:ext>
                </a:extLst>
              </p:cNvPr>
              <p:cNvSpPr txBox="1"/>
              <p:nvPr/>
            </p:nvSpPr>
            <p:spPr>
              <a:xfrm rot="18900000">
                <a:off x="2810926" y="516886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3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37CB99E-18CC-78FB-3F09-0291FBDD615D}"/>
                  </a:ext>
                </a:extLst>
              </p:cNvPr>
              <p:cNvSpPr txBox="1"/>
              <p:nvPr/>
            </p:nvSpPr>
            <p:spPr>
              <a:xfrm rot="18900000">
                <a:off x="3207885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3</a:t>
                </a:r>
              </a:p>
            </p:txBody>
          </p:sp>
        </p:grp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0ADCCDD-19C5-B6F0-B566-33B5690C7E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537566" y="1684154"/>
              <a:ext cx="3468925" cy="1585097"/>
            </a:xfrm>
            <a:prstGeom prst="rect">
              <a:avLst/>
            </a:prstGeom>
          </p:spPr>
        </p:pic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95D8B84B-6ED6-4119-760E-43DAA17406C1}"/>
                </a:ext>
              </a:extLst>
            </p:cNvPr>
            <p:cNvCxnSpPr/>
            <p:nvPr/>
          </p:nvCxnSpPr>
          <p:spPr>
            <a:xfrm>
              <a:off x="6277069" y="2804774"/>
              <a:ext cx="520995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5B77F8A-5340-4B78-D2C2-17FA079B531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25373" y="3429431"/>
              <a:ext cx="3481118" cy="1676545"/>
            </a:xfrm>
            <a:prstGeom prst="rect">
              <a:avLst/>
            </a:prstGeom>
          </p:spPr>
        </p:pic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E170089-7C0A-E624-A0E2-BFD257D68C33}"/>
                </a:ext>
              </a:extLst>
            </p:cNvPr>
            <p:cNvGrpSpPr/>
            <p:nvPr/>
          </p:nvGrpSpPr>
          <p:grpSpPr>
            <a:xfrm>
              <a:off x="6649309" y="942206"/>
              <a:ext cx="3561704" cy="468754"/>
              <a:chOff x="970839" y="418953"/>
              <a:chExt cx="3561704" cy="468754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45FD579-D2C9-4188-B1A2-80E43CA28720}"/>
                  </a:ext>
                </a:extLst>
              </p:cNvPr>
              <p:cNvSpPr txBox="1"/>
              <p:nvPr/>
            </p:nvSpPr>
            <p:spPr>
              <a:xfrm rot="18900000">
                <a:off x="970839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C4D34A7-3459-C01F-56DC-00137CB261C0}"/>
                  </a:ext>
                </a:extLst>
              </p:cNvPr>
              <p:cNvSpPr txBox="1"/>
              <p:nvPr/>
            </p:nvSpPr>
            <p:spPr>
              <a:xfrm rot="18900000">
                <a:off x="1331621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1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7C8F8D3-0087-FC73-DA66-FB296A0984E8}"/>
                  </a:ext>
                </a:extLst>
              </p:cNvPr>
              <p:cNvSpPr txBox="1"/>
              <p:nvPr/>
            </p:nvSpPr>
            <p:spPr>
              <a:xfrm rot="18900000">
                <a:off x="1873168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2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A115685-1D6C-96DC-1B50-E42FA4D52A7F}"/>
                  </a:ext>
                </a:extLst>
              </p:cNvPr>
              <p:cNvSpPr txBox="1"/>
              <p:nvPr/>
            </p:nvSpPr>
            <p:spPr>
              <a:xfrm rot="18900000">
                <a:off x="2328496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2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4F6E196-C87D-568E-A588-760F84494910}"/>
                  </a:ext>
                </a:extLst>
              </p:cNvPr>
              <p:cNvSpPr txBox="1"/>
              <p:nvPr/>
            </p:nvSpPr>
            <p:spPr>
              <a:xfrm rot="18900000">
                <a:off x="2810926" y="516886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3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5FF0340-67C0-E6C6-61CE-C7DCE92DB212}"/>
                  </a:ext>
                </a:extLst>
              </p:cNvPr>
              <p:cNvSpPr txBox="1"/>
              <p:nvPr/>
            </p:nvSpPr>
            <p:spPr>
              <a:xfrm rot="18900000">
                <a:off x="3207885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3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7C5E70E-75AB-8123-F2F2-D12BFB07E746}"/>
                </a:ext>
              </a:extLst>
            </p:cNvPr>
            <p:cNvSpPr txBox="1"/>
            <p:nvPr/>
          </p:nvSpPr>
          <p:spPr>
            <a:xfrm>
              <a:off x="7028388" y="5305857"/>
              <a:ext cx="3264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% Tris-glycine gel</a:t>
              </a:r>
              <a:endParaRPr lang="en-US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8804962-E114-E09F-5E41-5A637D5D2352}"/>
                </a:ext>
              </a:extLst>
            </p:cNvPr>
            <p:cNvSpPr txBox="1"/>
            <p:nvPr/>
          </p:nvSpPr>
          <p:spPr>
            <a:xfrm>
              <a:off x="4259706" y="2436416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62kD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E41A841-8F66-9DB1-C4F6-138A62117A50}"/>
                </a:ext>
              </a:extLst>
            </p:cNvPr>
            <p:cNvSpPr txBox="1"/>
            <p:nvPr/>
          </p:nvSpPr>
          <p:spPr>
            <a:xfrm>
              <a:off x="4295737" y="3729683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8kD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A2CB27E-BE7C-6730-BB55-0DA1CC1969E7}"/>
                </a:ext>
              </a:extLst>
            </p:cNvPr>
            <p:cNvSpPr txBox="1"/>
            <p:nvPr/>
          </p:nvSpPr>
          <p:spPr>
            <a:xfrm>
              <a:off x="10006491" y="3962359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8kD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CD3DF11-1D70-D53D-EE87-D689EC488C84}"/>
                </a:ext>
              </a:extLst>
            </p:cNvPr>
            <p:cNvSpPr txBox="1"/>
            <p:nvPr/>
          </p:nvSpPr>
          <p:spPr>
            <a:xfrm>
              <a:off x="10036039" y="2618861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62kDa</a:t>
              </a:r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0E7CD8CF-9041-CF3F-9797-576A9366FC12}"/>
              </a:ext>
            </a:extLst>
          </p:cNvPr>
          <p:cNvSpPr/>
          <p:nvPr/>
        </p:nvSpPr>
        <p:spPr>
          <a:xfrm>
            <a:off x="2402962" y="2369347"/>
            <a:ext cx="961536" cy="4670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365F65F-EDD2-FA5A-9DD9-922279650708}"/>
              </a:ext>
            </a:extLst>
          </p:cNvPr>
          <p:cNvSpPr/>
          <p:nvPr/>
        </p:nvSpPr>
        <p:spPr>
          <a:xfrm>
            <a:off x="2328530" y="3819506"/>
            <a:ext cx="929637" cy="4670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07999C5F-4248-ACC1-726E-CC82EE782F33}"/>
              </a:ext>
            </a:extLst>
          </p:cNvPr>
          <p:cNvSpPr/>
          <p:nvPr/>
        </p:nvSpPr>
        <p:spPr>
          <a:xfrm>
            <a:off x="7656692" y="2684630"/>
            <a:ext cx="788117" cy="3035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57D6BF2-85F4-870D-7209-DC1649553AE5}"/>
              </a:ext>
            </a:extLst>
          </p:cNvPr>
          <p:cNvSpPr/>
          <p:nvPr/>
        </p:nvSpPr>
        <p:spPr>
          <a:xfrm>
            <a:off x="7656692" y="4060469"/>
            <a:ext cx="788117" cy="3035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FE0A79D-9165-40FB-9851-6FB024055D81}"/>
              </a:ext>
            </a:extLst>
          </p:cNvPr>
          <p:cNvSpPr txBox="1"/>
          <p:nvPr/>
        </p:nvSpPr>
        <p:spPr>
          <a:xfrm>
            <a:off x="388314" y="6321973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DDA7FAC-2C24-7B25-C3C5-DD68F4CF5707}"/>
              </a:ext>
            </a:extLst>
          </p:cNvPr>
          <p:cNvSpPr txBox="1"/>
          <p:nvPr/>
        </p:nvSpPr>
        <p:spPr>
          <a:xfrm>
            <a:off x="5338136" y="243350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J-K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1429401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30FA2BF-7383-E703-F9A8-9A30C1E3EE5E}"/>
              </a:ext>
            </a:extLst>
          </p:cNvPr>
          <p:cNvGrpSpPr/>
          <p:nvPr/>
        </p:nvGrpSpPr>
        <p:grpSpPr>
          <a:xfrm>
            <a:off x="967278" y="750242"/>
            <a:ext cx="10281969" cy="5535818"/>
            <a:chOff x="967278" y="750242"/>
            <a:chExt cx="10281969" cy="5535818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93B7BA6-3C14-9C5E-0A07-58EA8323E6F7}"/>
                </a:ext>
              </a:extLst>
            </p:cNvPr>
            <p:cNvSpPr txBox="1"/>
            <p:nvPr/>
          </p:nvSpPr>
          <p:spPr>
            <a:xfrm>
              <a:off x="2179545" y="5873109"/>
              <a:ext cx="3264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% Tris-glycine gel</a:t>
              </a:r>
              <a:endParaRPr lang="en-US" dirty="0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A8931C4-07ED-647E-9714-07751E306A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67278" y="1411191"/>
              <a:ext cx="3700593" cy="1627773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242FD84-4961-36BA-A6AF-6E3919E2C2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67278" y="3103685"/>
              <a:ext cx="3731075" cy="114005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CFA14AD-3DDF-59AC-A5BC-DEABCCA2208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2518" y="4308457"/>
              <a:ext cx="3700593" cy="1499746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8ECD589-9D92-641A-7B2E-E48A3A91EDB6}"/>
                </a:ext>
              </a:extLst>
            </p:cNvPr>
            <p:cNvGrpSpPr/>
            <p:nvPr/>
          </p:nvGrpSpPr>
          <p:grpSpPr>
            <a:xfrm>
              <a:off x="1254369" y="750242"/>
              <a:ext cx="3561704" cy="468754"/>
              <a:chOff x="970839" y="418953"/>
              <a:chExt cx="3561704" cy="468754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C57FA00-4EAD-EDB2-EE08-0DA7C857B5BB}"/>
                  </a:ext>
                </a:extLst>
              </p:cNvPr>
              <p:cNvSpPr txBox="1"/>
              <p:nvPr/>
            </p:nvSpPr>
            <p:spPr>
              <a:xfrm rot="18900000">
                <a:off x="970839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4C8A0BE-EE1C-94EE-77A2-03B75966F70B}"/>
                  </a:ext>
                </a:extLst>
              </p:cNvPr>
              <p:cNvSpPr txBox="1"/>
              <p:nvPr/>
            </p:nvSpPr>
            <p:spPr>
              <a:xfrm rot="18900000">
                <a:off x="1331621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1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100E2FA-06B2-E7FD-84C8-7D258356D752}"/>
                  </a:ext>
                </a:extLst>
              </p:cNvPr>
              <p:cNvSpPr txBox="1"/>
              <p:nvPr/>
            </p:nvSpPr>
            <p:spPr>
              <a:xfrm rot="18900000">
                <a:off x="1873168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2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1FEF684-3802-395C-0EBD-122C9FE32902}"/>
                  </a:ext>
                </a:extLst>
              </p:cNvPr>
              <p:cNvSpPr txBox="1"/>
              <p:nvPr/>
            </p:nvSpPr>
            <p:spPr>
              <a:xfrm rot="18900000">
                <a:off x="2328496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2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52091736-D534-308D-F325-492A5853049C}"/>
                  </a:ext>
                </a:extLst>
              </p:cNvPr>
              <p:cNvSpPr txBox="1"/>
              <p:nvPr/>
            </p:nvSpPr>
            <p:spPr>
              <a:xfrm rot="18900000">
                <a:off x="2810926" y="516886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3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260F7C9-CA04-FF90-91E1-3B1207EEC8AB}"/>
                  </a:ext>
                </a:extLst>
              </p:cNvPr>
              <p:cNvSpPr txBox="1"/>
              <p:nvPr/>
            </p:nvSpPr>
            <p:spPr>
              <a:xfrm rot="18900000">
                <a:off x="3207885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3</a:t>
                </a:r>
              </a:p>
            </p:txBody>
          </p:sp>
        </p:grp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798CB11-C9A0-2CE2-33FF-4B375BDA08B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78052" y="1837064"/>
              <a:ext cx="3475442" cy="194573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0524A92-B85A-B957-BA7F-4D17A3E3A9E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63229" y="3836561"/>
              <a:ext cx="3490265" cy="1812624"/>
            </a:xfrm>
            <a:prstGeom prst="rect">
              <a:avLst/>
            </a:prstGeom>
          </p:spPr>
        </p:pic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FD521FF3-FD04-8DFE-AFB6-A6BF718654FF}"/>
                </a:ext>
              </a:extLst>
            </p:cNvPr>
            <p:cNvGrpSpPr/>
            <p:nvPr/>
          </p:nvGrpSpPr>
          <p:grpSpPr>
            <a:xfrm>
              <a:off x="6659305" y="1208815"/>
              <a:ext cx="3561704" cy="468754"/>
              <a:chOff x="970839" y="418953"/>
              <a:chExt cx="3561704" cy="468754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38E10F8-29B1-835E-D28D-E4F620DCE814}"/>
                  </a:ext>
                </a:extLst>
              </p:cNvPr>
              <p:cNvSpPr txBox="1"/>
              <p:nvPr/>
            </p:nvSpPr>
            <p:spPr>
              <a:xfrm rot="18900000">
                <a:off x="970839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1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0F4E186-1197-9462-A7AD-9C70AD91D04A}"/>
                  </a:ext>
                </a:extLst>
              </p:cNvPr>
              <p:cNvSpPr txBox="1"/>
              <p:nvPr/>
            </p:nvSpPr>
            <p:spPr>
              <a:xfrm rot="18900000">
                <a:off x="1331621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1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73E55E2-9461-1F97-A6A0-755DE58E8B3B}"/>
                  </a:ext>
                </a:extLst>
              </p:cNvPr>
              <p:cNvSpPr txBox="1"/>
              <p:nvPr/>
            </p:nvSpPr>
            <p:spPr>
              <a:xfrm rot="18900000">
                <a:off x="1873168" y="518375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2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E8021B2F-87B7-B074-840A-F97915314AA5}"/>
                  </a:ext>
                </a:extLst>
              </p:cNvPr>
              <p:cNvSpPr txBox="1"/>
              <p:nvPr/>
            </p:nvSpPr>
            <p:spPr>
              <a:xfrm rot="18900000">
                <a:off x="2328496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2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1C819FA-57DC-9E6B-F457-CDDCEC494C09}"/>
                  </a:ext>
                </a:extLst>
              </p:cNvPr>
              <p:cNvSpPr txBox="1"/>
              <p:nvPr/>
            </p:nvSpPr>
            <p:spPr>
              <a:xfrm rot="18900000">
                <a:off x="2810926" y="516886"/>
                <a:ext cx="10476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ntrol 3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1C87D7F0-BBB1-F617-BF0F-D2E7ED48D979}"/>
                  </a:ext>
                </a:extLst>
              </p:cNvPr>
              <p:cNvSpPr txBox="1"/>
              <p:nvPr/>
            </p:nvSpPr>
            <p:spPr>
              <a:xfrm rot="18900000">
                <a:off x="3207885" y="418953"/>
                <a:ext cx="13246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PGC1A-KO 3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726C51E-B24E-224A-2487-3C95E9CF368F}"/>
                </a:ext>
              </a:extLst>
            </p:cNvPr>
            <p:cNvSpPr txBox="1"/>
            <p:nvPr/>
          </p:nvSpPr>
          <p:spPr>
            <a:xfrm>
              <a:off x="7215032" y="5916728"/>
              <a:ext cx="3264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0% Tris-glycine gel</a:t>
              </a:r>
              <a:endParaRPr lang="en-US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99AD797-4D0E-7EB3-5A01-59C115B422BF}"/>
                </a:ext>
              </a:extLst>
            </p:cNvPr>
            <p:cNvSpPr txBox="1"/>
            <p:nvPr/>
          </p:nvSpPr>
          <p:spPr>
            <a:xfrm>
              <a:off x="10157596" y="2488019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10kD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96C566D-ADB4-E547-5DCF-A632A1876FE2}"/>
                </a:ext>
              </a:extLst>
            </p:cNvPr>
            <p:cNvSpPr txBox="1"/>
            <p:nvPr/>
          </p:nvSpPr>
          <p:spPr>
            <a:xfrm>
              <a:off x="4605547" y="4734579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2kD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8F4AB0C-AFE2-F42D-3246-C4ED21B79CC3}"/>
                </a:ext>
              </a:extLst>
            </p:cNvPr>
            <p:cNvSpPr txBox="1"/>
            <p:nvPr/>
          </p:nvSpPr>
          <p:spPr>
            <a:xfrm>
              <a:off x="10053494" y="4651250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8kD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DA2B217-6EA1-4004-CDA9-90C2C246FE05}"/>
                </a:ext>
              </a:extLst>
            </p:cNvPr>
            <p:cNvSpPr txBox="1"/>
            <p:nvPr/>
          </p:nvSpPr>
          <p:spPr>
            <a:xfrm>
              <a:off x="4667871" y="3673710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8kD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EDCD78A-A592-49D8-0CED-861CC392650C}"/>
                </a:ext>
              </a:extLst>
            </p:cNvPr>
            <p:cNvSpPr txBox="1"/>
            <p:nvPr/>
          </p:nvSpPr>
          <p:spPr>
            <a:xfrm>
              <a:off x="4623775" y="2508925"/>
              <a:ext cx="10916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60kDa</a:t>
              </a:r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AD71A97B-71B8-1154-461A-7C00752EFAC5}"/>
              </a:ext>
            </a:extLst>
          </p:cNvPr>
          <p:cNvSpPr/>
          <p:nvPr/>
        </p:nvSpPr>
        <p:spPr>
          <a:xfrm>
            <a:off x="2309379" y="2594024"/>
            <a:ext cx="788117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DA6D1A6-C049-4D7C-31B8-C1CA0DCD64F7}"/>
              </a:ext>
            </a:extLst>
          </p:cNvPr>
          <p:cNvSpPr/>
          <p:nvPr/>
        </p:nvSpPr>
        <p:spPr>
          <a:xfrm>
            <a:off x="2341278" y="3680584"/>
            <a:ext cx="788117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AF578553-87FD-C898-83F4-F6669A767BBF}"/>
              </a:ext>
            </a:extLst>
          </p:cNvPr>
          <p:cNvSpPr/>
          <p:nvPr/>
        </p:nvSpPr>
        <p:spPr>
          <a:xfrm>
            <a:off x="2341278" y="4744592"/>
            <a:ext cx="788117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096DF90-B0B4-46DE-D3CF-80FDE0DCABE6}"/>
              </a:ext>
            </a:extLst>
          </p:cNvPr>
          <p:cNvSpPr/>
          <p:nvPr/>
        </p:nvSpPr>
        <p:spPr>
          <a:xfrm>
            <a:off x="7637646" y="4744592"/>
            <a:ext cx="890201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95E0A61-4FDE-E88F-9210-5E2A73425EDE}"/>
              </a:ext>
            </a:extLst>
          </p:cNvPr>
          <p:cNvSpPr/>
          <p:nvPr/>
        </p:nvSpPr>
        <p:spPr>
          <a:xfrm>
            <a:off x="7637646" y="2509677"/>
            <a:ext cx="890201" cy="418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97D5274-7D47-A848-7530-D7545BC2D5FE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3ACD85F-B31E-BA9D-C7F9-BD9576A53CAD}"/>
              </a:ext>
            </a:extLst>
          </p:cNvPr>
          <p:cNvSpPr txBox="1"/>
          <p:nvPr/>
        </p:nvSpPr>
        <p:spPr>
          <a:xfrm>
            <a:off x="5338136" y="243350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6C-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6912501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DD3913E-511C-6476-79BF-A09BC14F1525}"/>
              </a:ext>
            </a:extLst>
          </p:cNvPr>
          <p:cNvSpPr txBox="1"/>
          <p:nvPr/>
        </p:nvSpPr>
        <p:spPr>
          <a:xfrm>
            <a:off x="693672" y="977715"/>
            <a:ext cx="95693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%-12% Bis-Tris gel, MES SDS running buffer, PGC1</a:t>
            </a:r>
            <a:r>
              <a:rPr lang="en-US" dirty="0">
                <a:latin typeface="Symbol" panose="05050102010706020507" pitchFamily="18" charset="2"/>
              </a:rPr>
              <a:t>a </a:t>
            </a:r>
            <a:r>
              <a:rPr lang="en-US" dirty="0"/>
              <a:t>run 100v 4hours, </a:t>
            </a:r>
            <a:r>
              <a:rPr lang="en-US" dirty="0">
                <a:latin typeface="Symbol" panose="05050102010706020507" pitchFamily="18" charset="2"/>
              </a:rPr>
              <a:t>b</a:t>
            </a:r>
            <a:r>
              <a:rPr lang="en-US" dirty="0"/>
              <a:t>-Tubulin run 100v 3hours. </a:t>
            </a: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1A76CB46-B82A-3634-0465-6114E07D73DE}"/>
              </a:ext>
            </a:extLst>
          </p:cNvPr>
          <p:cNvGrpSpPr/>
          <p:nvPr/>
        </p:nvGrpSpPr>
        <p:grpSpPr>
          <a:xfrm>
            <a:off x="782590" y="1530570"/>
            <a:ext cx="11409410" cy="3561936"/>
            <a:chOff x="1054385" y="2119533"/>
            <a:chExt cx="10795114" cy="3119547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AD4C9DC9-CF2A-497A-C8B7-94CFFEE34F50}"/>
                </a:ext>
              </a:extLst>
            </p:cNvPr>
            <p:cNvGrpSpPr/>
            <p:nvPr/>
          </p:nvGrpSpPr>
          <p:grpSpPr>
            <a:xfrm>
              <a:off x="1054385" y="2420326"/>
              <a:ext cx="9836164" cy="2818754"/>
              <a:chOff x="448329" y="2175777"/>
              <a:chExt cx="9836164" cy="2818754"/>
            </a:xfrm>
          </p:grpSpPr>
          <p:pic>
            <p:nvPicPr>
              <p:cNvPr id="6" name="Picture 5" descr="A picture containing text, white&#10;&#10;Description automatically generated">
                <a:extLst>
                  <a:ext uri="{FF2B5EF4-FFF2-40B4-BE49-F238E27FC236}">
                    <a16:creationId xmlns:a16="http://schemas.microsoft.com/office/drawing/2014/main" id="{D3A901B7-6506-9779-86B1-25CA5F4205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3440" y="2175777"/>
                <a:ext cx="3167149" cy="2804160"/>
              </a:xfrm>
              <a:prstGeom prst="rect">
                <a:avLst/>
              </a:prstGeom>
            </p:spPr>
          </p:pic>
          <p:pic>
            <p:nvPicPr>
              <p:cNvPr id="8" name="Picture 7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5346F975-6875-F917-7FF8-368F548FA0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07624" y="2197944"/>
                <a:ext cx="3200969" cy="2781993"/>
              </a:xfrm>
              <a:prstGeom prst="rect">
                <a:avLst/>
              </a:prstGeom>
            </p:spPr>
          </p:pic>
          <p:pic>
            <p:nvPicPr>
              <p:cNvPr id="10" name="Picture 9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7FB8DF4A-A465-0327-2E66-EAA23535C9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85628" y="2234706"/>
                <a:ext cx="2698865" cy="2759825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165F0EF-E9FA-2075-CE4F-53EABA00D27F}"/>
                  </a:ext>
                </a:extLst>
              </p:cNvPr>
              <p:cNvSpPr txBox="1"/>
              <p:nvPr/>
            </p:nvSpPr>
            <p:spPr>
              <a:xfrm>
                <a:off x="451566" y="3404256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9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202F358-8E5E-3A79-D99E-27F316821244}"/>
                  </a:ext>
                </a:extLst>
              </p:cNvPr>
              <p:cNvSpPr txBox="1"/>
              <p:nvPr/>
            </p:nvSpPr>
            <p:spPr>
              <a:xfrm>
                <a:off x="448329" y="3898073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1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9BED930-4868-4E7C-E85B-A4126D485250}"/>
                  </a:ext>
                </a:extLst>
              </p:cNvPr>
              <p:cNvSpPr txBox="1"/>
              <p:nvPr/>
            </p:nvSpPr>
            <p:spPr>
              <a:xfrm>
                <a:off x="486639" y="4316790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8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581F738-2371-2D77-4328-317D0C1EC24B}"/>
                  </a:ext>
                </a:extLst>
              </p:cNvPr>
              <p:cNvSpPr txBox="1"/>
              <p:nvPr/>
            </p:nvSpPr>
            <p:spPr>
              <a:xfrm>
                <a:off x="2124058" y="4246202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7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0092EA8-B2F9-455E-BE9F-B363BA8C6FE3}"/>
                  </a:ext>
                </a:extLst>
              </p:cNvPr>
              <p:cNvSpPr txBox="1"/>
              <p:nvPr/>
            </p:nvSpPr>
            <p:spPr>
              <a:xfrm>
                <a:off x="451566" y="314028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2CB24B0-4741-C9F8-EBD8-3732507B3EAF}"/>
                  </a:ext>
                </a:extLst>
              </p:cNvPr>
              <p:cNvSpPr txBox="1"/>
              <p:nvPr/>
            </p:nvSpPr>
            <p:spPr>
              <a:xfrm>
                <a:off x="2144934" y="4586828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50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4C2EEEC-2C08-D600-574F-F46A8799CEC7}"/>
                  </a:ext>
                </a:extLst>
              </p:cNvPr>
              <p:cNvSpPr txBox="1"/>
              <p:nvPr/>
            </p:nvSpPr>
            <p:spPr>
              <a:xfrm>
                <a:off x="492734" y="4654110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7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3D9BDE4-1452-4BF6-5DF6-8355EDA17407}"/>
                  </a:ext>
                </a:extLst>
              </p:cNvPr>
              <p:cNvSpPr txBox="1"/>
              <p:nvPr/>
            </p:nvSpPr>
            <p:spPr>
              <a:xfrm>
                <a:off x="2124058" y="3448058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15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3E8C8A7C-D361-0C0E-DE26-171AA7361075}"/>
                  </a:ext>
                </a:extLst>
              </p:cNvPr>
              <p:cNvSpPr txBox="1"/>
              <p:nvPr/>
            </p:nvSpPr>
            <p:spPr>
              <a:xfrm>
                <a:off x="2124058" y="3838272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8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6E8121C-C1D2-3CE7-1831-E261809803FE}"/>
                  </a:ext>
                </a:extLst>
              </p:cNvPr>
              <p:cNvSpPr txBox="1"/>
              <p:nvPr/>
            </p:nvSpPr>
            <p:spPr>
              <a:xfrm>
                <a:off x="2124058" y="2887692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9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3338FB9-EF67-7C31-F37E-F35E44FA507E}"/>
                  </a:ext>
                </a:extLst>
              </p:cNvPr>
              <p:cNvSpPr txBox="1"/>
              <p:nvPr/>
            </p:nvSpPr>
            <p:spPr>
              <a:xfrm>
                <a:off x="2144934" y="2683727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3ABF801-7D1A-9931-D30A-4F3884AEDB47}"/>
                  </a:ext>
                </a:extLst>
              </p:cNvPr>
              <p:cNvSpPr txBox="1"/>
              <p:nvPr/>
            </p:nvSpPr>
            <p:spPr>
              <a:xfrm>
                <a:off x="4066456" y="3255479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9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44983D9-2E81-3587-7186-A8EAEBAA14A5}"/>
                  </a:ext>
                </a:extLst>
              </p:cNvPr>
              <p:cNvSpPr txBox="1"/>
              <p:nvPr/>
            </p:nvSpPr>
            <p:spPr>
              <a:xfrm>
                <a:off x="4063219" y="3749296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15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F283529-0D20-B2DA-E53E-FD2F1F275B79}"/>
                  </a:ext>
                </a:extLst>
              </p:cNvPr>
              <p:cNvSpPr txBox="1"/>
              <p:nvPr/>
            </p:nvSpPr>
            <p:spPr>
              <a:xfrm>
                <a:off x="4101529" y="4168013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80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65B1FFC-BBD3-8C37-AF18-5C64D4A18A97}"/>
                  </a:ext>
                </a:extLst>
              </p:cNvPr>
              <p:cNvSpPr txBox="1"/>
              <p:nvPr/>
            </p:nvSpPr>
            <p:spPr>
              <a:xfrm>
                <a:off x="4066456" y="2991504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FD11380-2B7C-DEB8-16E2-78382D218B39}"/>
                  </a:ext>
                </a:extLst>
              </p:cNvPr>
              <p:cNvSpPr txBox="1"/>
              <p:nvPr/>
            </p:nvSpPr>
            <p:spPr>
              <a:xfrm>
                <a:off x="4107624" y="4505333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70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0392594-383B-D455-8EC2-48C52BE0D9A2}"/>
                  </a:ext>
                </a:extLst>
              </p:cNvPr>
              <p:cNvSpPr txBox="1"/>
              <p:nvPr/>
            </p:nvSpPr>
            <p:spPr>
              <a:xfrm>
                <a:off x="7288691" y="3231457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90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C041A341-A24B-AD1B-D899-9E44234AC518}"/>
                  </a:ext>
                </a:extLst>
              </p:cNvPr>
              <p:cNvSpPr txBox="1"/>
              <p:nvPr/>
            </p:nvSpPr>
            <p:spPr>
              <a:xfrm>
                <a:off x="7285454" y="3725274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15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582888A-EA39-B1F4-C85B-40B14C12C8DA}"/>
                  </a:ext>
                </a:extLst>
              </p:cNvPr>
              <p:cNvSpPr txBox="1"/>
              <p:nvPr/>
            </p:nvSpPr>
            <p:spPr>
              <a:xfrm>
                <a:off x="7323764" y="414399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80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2453537-EFBA-4541-2DEE-696F0DDDB74E}"/>
                  </a:ext>
                </a:extLst>
              </p:cNvPr>
              <p:cNvSpPr txBox="1"/>
              <p:nvPr/>
            </p:nvSpPr>
            <p:spPr>
              <a:xfrm>
                <a:off x="7288691" y="2967482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302D108-FF90-4810-D5BC-8D9C361C43CC}"/>
                  </a:ext>
                </a:extLst>
              </p:cNvPr>
              <p:cNvSpPr txBox="1"/>
              <p:nvPr/>
            </p:nvSpPr>
            <p:spPr>
              <a:xfrm>
                <a:off x="7329859" y="448131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70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E3CB1E6-1629-02A3-798F-1140B26E2CD8}"/>
                  </a:ext>
                </a:extLst>
              </p:cNvPr>
              <p:cNvSpPr txBox="1"/>
              <p:nvPr/>
            </p:nvSpPr>
            <p:spPr>
              <a:xfrm>
                <a:off x="5667248" y="430556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70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61714DA-5FA0-0E84-4618-A118A6D3C9C2}"/>
                  </a:ext>
                </a:extLst>
              </p:cNvPr>
              <p:cNvSpPr txBox="1"/>
              <p:nvPr/>
            </p:nvSpPr>
            <p:spPr>
              <a:xfrm>
                <a:off x="5713293" y="4586828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50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13C82E5-02DC-6E6F-EC45-6BB357F4FE29}"/>
                  </a:ext>
                </a:extLst>
              </p:cNvPr>
              <p:cNvSpPr txBox="1"/>
              <p:nvPr/>
            </p:nvSpPr>
            <p:spPr>
              <a:xfrm>
                <a:off x="5627740" y="3703927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15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D48AADFA-3CEC-ED01-A6B9-80B9B267B66A}"/>
                  </a:ext>
                </a:extLst>
              </p:cNvPr>
              <p:cNvSpPr txBox="1"/>
              <p:nvPr/>
            </p:nvSpPr>
            <p:spPr>
              <a:xfrm>
                <a:off x="5667248" y="403305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80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3FE8F122-EB2B-22A6-6D66-DFB25685D931}"/>
                  </a:ext>
                </a:extLst>
              </p:cNvPr>
              <p:cNvSpPr txBox="1"/>
              <p:nvPr/>
            </p:nvSpPr>
            <p:spPr>
              <a:xfrm>
                <a:off x="5606864" y="326275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90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1E662911-292E-5A3F-D1C2-FAFFD32DFA44}"/>
                  </a:ext>
                </a:extLst>
              </p:cNvPr>
              <p:cNvSpPr txBox="1"/>
              <p:nvPr/>
            </p:nvSpPr>
            <p:spPr>
              <a:xfrm>
                <a:off x="5627740" y="3058786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84CB400E-0334-FCF1-A275-7C672DC85F4E}"/>
                  </a:ext>
                </a:extLst>
              </p:cNvPr>
              <p:cNvSpPr txBox="1"/>
              <p:nvPr/>
            </p:nvSpPr>
            <p:spPr>
              <a:xfrm>
                <a:off x="8822172" y="4200044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70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2C8A9904-D0A2-88BD-0574-D917BDD1C9A5}"/>
                  </a:ext>
                </a:extLst>
              </p:cNvPr>
              <p:cNvSpPr txBox="1"/>
              <p:nvPr/>
            </p:nvSpPr>
            <p:spPr>
              <a:xfrm>
                <a:off x="8868217" y="4481311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5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9689CAE0-E909-5888-4230-A1EC7634F4FC}"/>
                  </a:ext>
                </a:extLst>
              </p:cNvPr>
              <p:cNvSpPr txBox="1"/>
              <p:nvPr/>
            </p:nvSpPr>
            <p:spPr>
              <a:xfrm>
                <a:off x="8782664" y="3598410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1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6C523D70-035C-EF5E-5A9C-6C802499ECE4}"/>
                  </a:ext>
                </a:extLst>
              </p:cNvPr>
              <p:cNvSpPr txBox="1"/>
              <p:nvPr/>
            </p:nvSpPr>
            <p:spPr>
              <a:xfrm>
                <a:off x="8822172" y="3927534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80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B9D724E3-20D7-C2BB-95D8-4CE906D58F97}"/>
                  </a:ext>
                </a:extLst>
              </p:cNvPr>
              <p:cNvSpPr txBox="1"/>
              <p:nvPr/>
            </p:nvSpPr>
            <p:spPr>
              <a:xfrm>
                <a:off x="8761788" y="3157234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190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6BABEDBD-1697-D3F0-DA3D-E3A1E514E069}"/>
                  </a:ext>
                </a:extLst>
              </p:cNvPr>
              <p:cNvSpPr txBox="1"/>
              <p:nvPr/>
            </p:nvSpPr>
            <p:spPr>
              <a:xfrm>
                <a:off x="8782664" y="2953269"/>
                <a:ext cx="765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FA6A223-3748-BAFD-39F7-DC08C3CB31FB}"/>
                </a:ext>
              </a:extLst>
            </p:cNvPr>
            <p:cNvSpPr txBox="1"/>
            <p:nvPr/>
          </p:nvSpPr>
          <p:spPr>
            <a:xfrm>
              <a:off x="1229522" y="2222360"/>
              <a:ext cx="38875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dirty="0"/>
                <a:t>PGC1</a:t>
              </a:r>
              <a:r>
                <a:rPr lang="en-US" sz="1600" dirty="0">
                  <a:latin typeface="Symbol" panose="05050102010706020507" pitchFamily="18" charset="2"/>
                </a:rPr>
                <a:t>a </a:t>
              </a:r>
              <a:r>
                <a:rPr lang="en-US" sz="1600" dirty="0"/>
                <a:t>77.14 </a:t>
              </a:r>
              <a:r>
                <a:rPr lang="en-US" sz="1600" dirty="0" err="1"/>
                <a:t>kDa</a:t>
              </a:r>
              <a:r>
                <a:rPr lang="en-US" sz="1600" dirty="0"/>
                <a:t>   </a:t>
              </a:r>
              <a:r>
                <a:rPr lang="en-US" sz="1600" dirty="0">
                  <a:latin typeface="Symbol" panose="05050102010706020507" pitchFamily="18" charset="2"/>
                </a:rPr>
                <a:t>b</a:t>
              </a:r>
              <a:r>
                <a:rPr lang="en-US" sz="1600" dirty="0"/>
                <a:t>-Tubulin 55kD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E10E60EC-6AEA-89E0-3A84-DE573600861C}"/>
                </a:ext>
              </a:extLst>
            </p:cNvPr>
            <p:cNvSpPr txBox="1"/>
            <p:nvPr/>
          </p:nvSpPr>
          <p:spPr>
            <a:xfrm>
              <a:off x="4648519" y="2151807"/>
              <a:ext cx="38875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dirty="0"/>
                <a:t>PGC1</a:t>
              </a:r>
              <a:r>
                <a:rPr lang="en-US" sz="1600" dirty="0">
                  <a:latin typeface="Symbol" panose="05050102010706020507" pitchFamily="18" charset="2"/>
                </a:rPr>
                <a:t>a </a:t>
              </a:r>
              <a:r>
                <a:rPr lang="en-US" sz="1600" dirty="0"/>
                <a:t>77.14 </a:t>
              </a:r>
              <a:r>
                <a:rPr lang="en-US" sz="1600" dirty="0" err="1"/>
                <a:t>kDa</a:t>
              </a:r>
              <a:r>
                <a:rPr lang="en-US" sz="1600" dirty="0"/>
                <a:t>   </a:t>
              </a:r>
              <a:r>
                <a:rPr lang="en-US" sz="1600" dirty="0">
                  <a:latin typeface="Symbol" panose="05050102010706020507" pitchFamily="18" charset="2"/>
                </a:rPr>
                <a:t>b</a:t>
              </a:r>
              <a:r>
                <a:rPr lang="en-US" sz="1600" dirty="0"/>
                <a:t>-Tubulin 55kD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2815187-A9E6-A256-9E41-918910FAF09B}"/>
                </a:ext>
              </a:extLst>
            </p:cNvPr>
            <p:cNvSpPr txBox="1"/>
            <p:nvPr/>
          </p:nvSpPr>
          <p:spPr>
            <a:xfrm>
              <a:off x="7961998" y="2119533"/>
              <a:ext cx="38875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dirty="0"/>
                <a:t>PGC1</a:t>
              </a:r>
              <a:r>
                <a:rPr lang="en-US" sz="1600" dirty="0">
                  <a:latin typeface="Symbol" panose="05050102010706020507" pitchFamily="18" charset="2"/>
                </a:rPr>
                <a:t>a </a:t>
              </a:r>
              <a:r>
                <a:rPr lang="en-US" sz="1600" dirty="0"/>
                <a:t>77.14 </a:t>
              </a:r>
              <a:r>
                <a:rPr lang="en-US" sz="1600" dirty="0" err="1"/>
                <a:t>kDa</a:t>
              </a:r>
              <a:r>
                <a:rPr lang="en-US" sz="1600" dirty="0"/>
                <a:t>   </a:t>
              </a:r>
              <a:r>
                <a:rPr lang="en-US" sz="1600" dirty="0">
                  <a:latin typeface="Symbol" panose="05050102010706020507" pitchFamily="18" charset="2"/>
                </a:rPr>
                <a:t>b</a:t>
              </a:r>
              <a:r>
                <a:rPr lang="en-US" sz="1600" dirty="0"/>
                <a:t>-Tubulin 55kDa</a:t>
              </a:r>
            </a:p>
          </p:txBody>
        </p: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EA4E7EC5-8919-6BCE-B75C-F63B75DF4D29}"/>
                </a:ext>
              </a:extLst>
            </p:cNvPr>
            <p:cNvCxnSpPr/>
            <p:nvPr/>
          </p:nvCxnSpPr>
          <p:spPr>
            <a:xfrm>
              <a:off x="1103328" y="4877393"/>
              <a:ext cx="565984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9D72C5A8-E9C5-F1A8-93D4-8D5E2BBBC172}"/>
                </a:ext>
              </a:extLst>
            </p:cNvPr>
            <p:cNvCxnSpPr/>
            <p:nvPr/>
          </p:nvCxnSpPr>
          <p:spPr>
            <a:xfrm flipV="1">
              <a:off x="4617040" y="4675051"/>
              <a:ext cx="523634" cy="1891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2FBD2D8E-BE71-EEED-8AAC-C8E34CCEFEB2}"/>
                </a:ext>
              </a:extLst>
            </p:cNvPr>
            <p:cNvCxnSpPr/>
            <p:nvPr/>
          </p:nvCxnSpPr>
          <p:spPr>
            <a:xfrm flipV="1">
              <a:off x="7961998" y="4644639"/>
              <a:ext cx="574022" cy="304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5B9DD12F-4BBC-30C5-0833-64009C718B2B}"/>
              </a:ext>
            </a:extLst>
          </p:cNvPr>
          <p:cNvSpPr txBox="1"/>
          <p:nvPr/>
        </p:nvSpPr>
        <p:spPr>
          <a:xfrm>
            <a:off x="1130881" y="5540069"/>
            <a:ext cx="87260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/>
              <a:t>Thermo</a:t>
            </a:r>
            <a:r>
              <a:rPr lang="en-US" sz="1600" dirty="0"/>
              <a:t> Scientific™  </a:t>
            </a:r>
            <a:r>
              <a:rPr lang="en-US" sz="1600" dirty="0" err="1"/>
              <a:t>PageRuler</a:t>
            </a:r>
            <a:r>
              <a:rPr lang="en-US" sz="1600" dirty="0"/>
              <a:t> Plus </a:t>
            </a:r>
            <a:r>
              <a:rPr lang="en-US" sz="1600" dirty="0" err="1"/>
              <a:t>Prestained</a:t>
            </a:r>
            <a:r>
              <a:rPr lang="en-US" sz="1600" dirty="0"/>
              <a:t> Protein Ladder 10-250kDa</a:t>
            </a:r>
          </a:p>
          <a:p>
            <a:r>
              <a:rPr lang="en-US" sz="1600" dirty="0" err="1"/>
              <a:t>Thermofisher</a:t>
            </a:r>
            <a:r>
              <a:rPr lang="en-US" sz="1600" dirty="0"/>
              <a:t> Cat: 26619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8A5EB89-105A-B5A3-47FD-666FF5AC73A4}"/>
              </a:ext>
            </a:extLst>
          </p:cNvPr>
          <p:cNvSpPr/>
          <p:nvPr/>
        </p:nvSpPr>
        <p:spPr>
          <a:xfrm>
            <a:off x="5196723" y="4405009"/>
            <a:ext cx="899277" cy="1205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EC2BF29-3A73-33CA-7DC7-7DC54AA04ED3}"/>
              </a:ext>
            </a:extLst>
          </p:cNvPr>
          <p:cNvSpPr/>
          <p:nvPr/>
        </p:nvSpPr>
        <p:spPr>
          <a:xfrm>
            <a:off x="6879265" y="4626986"/>
            <a:ext cx="1045125" cy="311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0AECB6-DA49-AA67-AE32-502334EB8815}"/>
              </a:ext>
            </a:extLst>
          </p:cNvPr>
          <p:cNvSpPr txBox="1"/>
          <p:nvPr/>
        </p:nvSpPr>
        <p:spPr>
          <a:xfrm>
            <a:off x="693672" y="179057"/>
            <a:ext cx="3196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Supplementary F</a:t>
            </a:r>
            <a:r>
              <a:rPr lang="en-US" altLang="zh-CN" b="1" dirty="0"/>
              <a:t>igure 1 C-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5377952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picture containing text, electronics, close&#10;&#10;Description automatically generated">
            <a:extLst>
              <a:ext uri="{FF2B5EF4-FFF2-40B4-BE49-F238E27FC236}">
                <a16:creationId xmlns:a16="http://schemas.microsoft.com/office/drawing/2014/main" id="{66B9BBE2-A322-BE87-BC1C-0C215AA9B15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10419" b="-13304"/>
          <a:stretch/>
        </p:blipFill>
        <p:spPr>
          <a:xfrm>
            <a:off x="561009" y="3845071"/>
            <a:ext cx="4001034" cy="2347714"/>
          </a:xfrm>
          <a:prstGeom prst="rect">
            <a:avLst/>
          </a:prstGeom>
        </p:spPr>
      </p:pic>
      <p:pic>
        <p:nvPicPr>
          <p:cNvPr id="21" name="Picture 20" descr="A picture containing text, close&#10;&#10;Description automatically generated">
            <a:extLst>
              <a:ext uri="{FF2B5EF4-FFF2-40B4-BE49-F238E27FC236}">
                <a16:creationId xmlns:a16="http://schemas.microsoft.com/office/drawing/2014/main" id="{B23BE36D-9C2A-9EC7-C4B2-25A8F83C337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7770" b="-21224"/>
          <a:stretch/>
        </p:blipFill>
        <p:spPr>
          <a:xfrm>
            <a:off x="407090" y="1204828"/>
            <a:ext cx="4008696" cy="22977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3158AB3-52C7-03AB-C7FA-52BF3961CDC7}"/>
              </a:ext>
            </a:extLst>
          </p:cNvPr>
          <p:cNvSpPr txBox="1"/>
          <p:nvPr/>
        </p:nvSpPr>
        <p:spPr>
          <a:xfrm>
            <a:off x="4041888" y="2029845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FATP2 70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85CE6C-7870-09D5-BD51-8C76F86975E8}"/>
              </a:ext>
            </a:extLst>
          </p:cNvPr>
          <p:cNvSpPr txBox="1"/>
          <p:nvPr/>
        </p:nvSpPr>
        <p:spPr>
          <a:xfrm>
            <a:off x="4071556" y="4136989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GAPDH 38 </a:t>
            </a:r>
            <a:r>
              <a:rPr lang="en-US" dirty="0" err="1"/>
              <a:t>kDa</a:t>
            </a:r>
            <a:endParaRPr lang="en-US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DB49BA9-E863-8880-3C8B-80E90DFFA9B0}"/>
              </a:ext>
            </a:extLst>
          </p:cNvPr>
          <p:cNvGrpSpPr/>
          <p:nvPr/>
        </p:nvGrpSpPr>
        <p:grpSpPr>
          <a:xfrm>
            <a:off x="939499" y="810739"/>
            <a:ext cx="3561704" cy="468754"/>
            <a:chOff x="970839" y="418953"/>
            <a:chExt cx="3561704" cy="46875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004B0EE-10D4-27A9-64C5-AF9888D4D3C8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D87EC8E-91E3-7E6F-AC3A-27B793F96AAE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CA911FD-1926-CB32-7783-271DC8E73A23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9A3214E-C29B-A622-17BB-AC1D86C80E01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8AE5491-4EBA-05BA-0AC0-1EED9F05CBA7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309E9E1-D1FF-5196-0ADA-8787C84EBEC4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CD016E1-7C9B-78F7-3C30-AB5460773A0B}"/>
              </a:ext>
            </a:extLst>
          </p:cNvPr>
          <p:cNvGrpSpPr/>
          <p:nvPr/>
        </p:nvGrpSpPr>
        <p:grpSpPr>
          <a:xfrm>
            <a:off x="1235427" y="3615966"/>
            <a:ext cx="3561704" cy="468754"/>
            <a:chOff x="970839" y="418953"/>
            <a:chExt cx="3561704" cy="46875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AB9F741-9A62-2AD7-59DE-E2566CC64216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8FD9242-49EF-A65D-FA94-EFCE43749668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AF8F9DF-4E39-36F4-0721-32C4832F69D9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01851A7-9909-6808-71DF-EA8F6B73123F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5C81572-D7CD-D9C2-B508-C05B94021629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465BE1A-5BDE-4DE8-4AA6-4A74F780BECF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135E18B4-AE14-31F0-D04E-4B9D13EFFAF2}"/>
              </a:ext>
            </a:extLst>
          </p:cNvPr>
          <p:cNvSpPr txBox="1"/>
          <p:nvPr/>
        </p:nvSpPr>
        <p:spPr>
          <a:xfrm>
            <a:off x="1526108" y="5894823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E76A060-2B0F-088C-266B-F7605D78F8BF}"/>
              </a:ext>
            </a:extLst>
          </p:cNvPr>
          <p:cNvSpPr txBox="1"/>
          <p:nvPr/>
        </p:nvSpPr>
        <p:spPr>
          <a:xfrm>
            <a:off x="9871396" y="2866610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PAR</a:t>
            </a:r>
            <a:r>
              <a:rPr lang="en-US" dirty="0" err="1">
                <a:latin typeface="Symbol" panose="05050102010706020507" pitchFamily="18" charset="2"/>
              </a:rPr>
              <a:t>g</a:t>
            </a:r>
            <a:r>
              <a:rPr lang="en-US" dirty="0">
                <a:latin typeface="Symbol" panose="05050102010706020507" pitchFamily="18" charset="2"/>
              </a:rPr>
              <a:t> </a:t>
            </a:r>
            <a:r>
              <a:rPr lang="en-US" dirty="0"/>
              <a:t> 5</a:t>
            </a:r>
            <a:r>
              <a:rPr lang="en-US" altLang="zh-CN" dirty="0"/>
              <a:t>8</a:t>
            </a:r>
            <a:r>
              <a:rPr lang="en-US" dirty="0"/>
              <a:t>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E8C338E-5017-8362-DF29-9BB05D105C6D}"/>
              </a:ext>
            </a:extLst>
          </p:cNvPr>
          <p:cNvSpPr txBox="1"/>
          <p:nvPr/>
        </p:nvSpPr>
        <p:spPr>
          <a:xfrm>
            <a:off x="9871397" y="3845085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pic>
        <p:nvPicPr>
          <p:cNvPr id="44" name="Picture 43" descr="A picture containing blur&#10;&#10;Description automatically generated">
            <a:extLst>
              <a:ext uri="{FF2B5EF4-FFF2-40B4-BE49-F238E27FC236}">
                <a16:creationId xmlns:a16="http://schemas.microsoft.com/office/drawing/2014/main" id="{18488081-22C5-A028-B5B2-8A243F682EA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746" r="-2228" b="-7418"/>
          <a:stretch/>
        </p:blipFill>
        <p:spPr>
          <a:xfrm>
            <a:off x="6319956" y="2772995"/>
            <a:ext cx="3655414" cy="678213"/>
          </a:xfrm>
          <a:prstGeom prst="rect">
            <a:avLst/>
          </a:prstGeom>
        </p:spPr>
      </p:pic>
      <p:pic>
        <p:nvPicPr>
          <p:cNvPr id="45" name="Picture 44" descr="A close-up of a calculator&#10;&#10;Description automatically generated">
            <a:extLst>
              <a:ext uri="{FF2B5EF4-FFF2-40B4-BE49-F238E27FC236}">
                <a16:creationId xmlns:a16="http://schemas.microsoft.com/office/drawing/2014/main" id="{C79857E3-C556-F4E2-02CF-4096AF06B7A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9956" y="3499066"/>
            <a:ext cx="3571521" cy="1902776"/>
          </a:xfrm>
          <a:prstGeom prst="rect">
            <a:avLst/>
          </a:prstGeom>
        </p:spPr>
      </p:pic>
      <p:grpSp>
        <p:nvGrpSpPr>
          <p:cNvPr id="46" name="Group 45">
            <a:extLst>
              <a:ext uri="{FF2B5EF4-FFF2-40B4-BE49-F238E27FC236}">
                <a16:creationId xmlns:a16="http://schemas.microsoft.com/office/drawing/2014/main" id="{7B93D4E6-67B1-A380-A4C5-7E61C9AB413D}"/>
              </a:ext>
            </a:extLst>
          </p:cNvPr>
          <p:cNvGrpSpPr/>
          <p:nvPr/>
        </p:nvGrpSpPr>
        <p:grpSpPr>
          <a:xfrm>
            <a:off x="6572772" y="2139550"/>
            <a:ext cx="3561704" cy="468754"/>
            <a:chOff x="970839" y="418953"/>
            <a:chExt cx="3561704" cy="468754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611B2DE-0A81-37D0-1602-73AFEBA27A29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69F50E0-65CD-0F86-276A-EC5987F6EBF9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39B7BFB-92DA-7AF9-CDEC-D1F55E206840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4791F1A-DEFD-A08A-B9B6-A0AE9457CB69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A5E1B49-5CB6-EF96-22FC-907FFE92CC9A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C7F1A6E-D914-0BEF-2D8D-3F6EAB65ED05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5E94CE3C-EE9E-4678-56F3-0D2B24EE3776}"/>
              </a:ext>
            </a:extLst>
          </p:cNvPr>
          <p:cNvSpPr txBox="1"/>
          <p:nvPr/>
        </p:nvSpPr>
        <p:spPr>
          <a:xfrm>
            <a:off x="7476898" y="5636123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029719F-722C-DD14-6056-D6F8962FFB96}"/>
              </a:ext>
            </a:extLst>
          </p:cNvPr>
          <p:cNvSpPr/>
          <p:nvPr/>
        </p:nvSpPr>
        <p:spPr>
          <a:xfrm>
            <a:off x="8340013" y="2866610"/>
            <a:ext cx="851661" cy="4303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47423BB-736E-BA13-7CC7-78979D0C996B}"/>
              </a:ext>
            </a:extLst>
          </p:cNvPr>
          <p:cNvSpPr/>
          <p:nvPr/>
        </p:nvSpPr>
        <p:spPr>
          <a:xfrm>
            <a:off x="8323259" y="3737352"/>
            <a:ext cx="844679" cy="4923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B13551-C141-4065-9C1D-4F88C633563D}"/>
              </a:ext>
            </a:extLst>
          </p:cNvPr>
          <p:cNvSpPr txBox="1"/>
          <p:nvPr/>
        </p:nvSpPr>
        <p:spPr>
          <a:xfrm>
            <a:off x="7441562" y="1283048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B-C</a:t>
            </a:r>
            <a:endParaRPr lang="en-US" b="1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5CAE329-5560-7516-661E-5B2668DDFBE3}"/>
              </a:ext>
            </a:extLst>
          </p:cNvPr>
          <p:cNvSpPr/>
          <p:nvPr/>
        </p:nvSpPr>
        <p:spPr>
          <a:xfrm>
            <a:off x="2102355" y="4321655"/>
            <a:ext cx="902329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7C22FBE-CDF4-698A-1407-4F3E1ACD663E}"/>
              </a:ext>
            </a:extLst>
          </p:cNvPr>
          <p:cNvSpPr/>
          <p:nvPr/>
        </p:nvSpPr>
        <p:spPr>
          <a:xfrm>
            <a:off x="1955125" y="2042121"/>
            <a:ext cx="902329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E8E2208-0A80-C80E-93C0-086F7F698A7A}"/>
              </a:ext>
            </a:extLst>
          </p:cNvPr>
          <p:cNvSpPr txBox="1"/>
          <p:nvPr/>
        </p:nvSpPr>
        <p:spPr>
          <a:xfrm>
            <a:off x="1783529" y="86013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D-E</a:t>
            </a:r>
            <a:endParaRPr lang="en-US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066BB36-07FD-A746-B8E4-750FD632A3C7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364702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calculator&#10;&#10;Description automatically generated with medium confidence">
            <a:extLst>
              <a:ext uri="{FF2B5EF4-FFF2-40B4-BE49-F238E27FC236}">
                <a16:creationId xmlns:a16="http://schemas.microsoft.com/office/drawing/2014/main" id="{E916C44D-551B-894B-ABBB-93B342A87D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5247" y="1310681"/>
            <a:ext cx="3562350" cy="2952973"/>
          </a:xfrm>
          <a:prstGeom prst="rect">
            <a:avLst/>
          </a:prstGeom>
        </p:spPr>
      </p:pic>
      <p:pic>
        <p:nvPicPr>
          <p:cNvPr id="7" name="Picture 6" descr="A picture containing text, indoor, close&#10;&#10;Description automatically generated">
            <a:extLst>
              <a:ext uri="{FF2B5EF4-FFF2-40B4-BE49-F238E27FC236}">
                <a16:creationId xmlns:a16="http://schemas.microsoft.com/office/drawing/2014/main" id="{5C79B433-19D5-CD97-5EC2-4912A4EE40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258" y="1294392"/>
            <a:ext cx="3867150" cy="2447925"/>
          </a:xfrm>
          <a:prstGeom prst="rect">
            <a:avLst/>
          </a:prstGeom>
        </p:spPr>
      </p:pic>
      <p:pic>
        <p:nvPicPr>
          <p:cNvPr id="9" name="Picture 8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F945375A-6A61-C211-B294-BB554762DC8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258" y="3942122"/>
            <a:ext cx="3867150" cy="2200275"/>
          </a:xfrm>
          <a:prstGeom prst="rect">
            <a:avLst/>
          </a:prstGeom>
        </p:spPr>
      </p:pic>
      <p:pic>
        <p:nvPicPr>
          <p:cNvPr id="11" name="Picture 10" descr="A picture containing text, device, close&#10;&#10;Description automatically generated">
            <a:extLst>
              <a:ext uri="{FF2B5EF4-FFF2-40B4-BE49-F238E27FC236}">
                <a16:creationId xmlns:a16="http://schemas.microsoft.com/office/drawing/2014/main" id="{ADAD9AB6-16FA-B18C-CBCB-13118099F29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6197" y="4369542"/>
            <a:ext cx="3581400" cy="20955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1F42471-1895-CB2F-4A84-54A10592CEC5}"/>
              </a:ext>
            </a:extLst>
          </p:cNvPr>
          <p:cNvSpPr txBox="1"/>
          <p:nvPr/>
        </p:nvSpPr>
        <p:spPr>
          <a:xfrm>
            <a:off x="1743622" y="6157536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9212B07-745F-4036-88C1-D26BD6805C6B}"/>
              </a:ext>
            </a:extLst>
          </p:cNvPr>
          <p:cNvSpPr txBox="1"/>
          <p:nvPr/>
        </p:nvSpPr>
        <p:spPr>
          <a:xfrm>
            <a:off x="7460444" y="6362610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FE75911-D7D2-F0A8-DDDD-3EB8B2074C94}"/>
              </a:ext>
            </a:extLst>
          </p:cNvPr>
          <p:cNvCxnSpPr/>
          <p:nvPr/>
        </p:nvCxnSpPr>
        <p:spPr>
          <a:xfrm>
            <a:off x="495547" y="2044419"/>
            <a:ext cx="89313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E03C620-FE9E-7441-FC20-F756C8E0D1B1}"/>
              </a:ext>
            </a:extLst>
          </p:cNvPr>
          <p:cNvCxnSpPr>
            <a:cxnSpLocks/>
          </p:cNvCxnSpPr>
          <p:nvPr/>
        </p:nvCxnSpPr>
        <p:spPr>
          <a:xfrm flipH="1">
            <a:off x="9569297" y="3910788"/>
            <a:ext cx="92842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018607E-F7B1-90D4-6C4A-B4654EC2FE92}"/>
              </a:ext>
            </a:extLst>
          </p:cNvPr>
          <p:cNvSpPr txBox="1"/>
          <p:nvPr/>
        </p:nvSpPr>
        <p:spPr>
          <a:xfrm>
            <a:off x="4409939" y="1935225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PT1A  88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A7D4B6-6CC8-64FE-F9D9-00DC504B1A1A}"/>
              </a:ext>
            </a:extLst>
          </p:cNvPr>
          <p:cNvSpPr txBox="1"/>
          <p:nvPr/>
        </p:nvSpPr>
        <p:spPr>
          <a:xfrm>
            <a:off x="4387346" y="4296186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DC98813-95EB-49CF-7853-D05A2D1A2600}"/>
              </a:ext>
            </a:extLst>
          </p:cNvPr>
          <p:cNvSpPr txBox="1"/>
          <p:nvPr/>
        </p:nvSpPr>
        <p:spPr>
          <a:xfrm>
            <a:off x="10237597" y="4695330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B31E2A-F9C9-A54B-9889-BAD45E428CF7}"/>
              </a:ext>
            </a:extLst>
          </p:cNvPr>
          <p:cNvSpPr txBox="1"/>
          <p:nvPr/>
        </p:nvSpPr>
        <p:spPr>
          <a:xfrm>
            <a:off x="10451485" y="371098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OAT1 45kDa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48A12F6-E332-8B39-A25A-A83733241F81}"/>
              </a:ext>
            </a:extLst>
          </p:cNvPr>
          <p:cNvGrpSpPr/>
          <p:nvPr/>
        </p:nvGrpSpPr>
        <p:grpSpPr>
          <a:xfrm>
            <a:off x="1404646" y="782536"/>
            <a:ext cx="3561704" cy="468754"/>
            <a:chOff x="970839" y="418953"/>
            <a:chExt cx="3561704" cy="468754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5F92DFA-133E-6BA4-0FE3-0EB326A1C781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57D03A3-F417-6A41-FB8B-47AB8B787220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68B17D7-3A9D-C8F2-953C-3AD96A2D65F2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32EF96A-BA34-6DC4-FCA2-9AD021C70CAC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A16B333-59DE-0852-0248-56309CCA96A1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E2A6691-0140-F959-2D2D-22BF6DD62678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7982DB8-63F1-B8B0-BF60-B7A55377A911}"/>
              </a:ext>
            </a:extLst>
          </p:cNvPr>
          <p:cNvGrpSpPr/>
          <p:nvPr/>
        </p:nvGrpSpPr>
        <p:grpSpPr>
          <a:xfrm>
            <a:off x="6856645" y="754786"/>
            <a:ext cx="3561704" cy="468754"/>
            <a:chOff x="970839" y="418953"/>
            <a:chExt cx="3561704" cy="468754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F6DE6C2-D865-2EAD-7EC1-D091B754A013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BDCD7B8-9CF6-D5F2-8B84-DAEED25D5E80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908A24F-5F43-D6C4-F451-36742A355375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BA48C2D-87C0-16BA-681B-42728CE94A24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79A1752-57C5-5D21-6489-1F24FB576EB3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AF5A793-E050-423B-56C7-351B505B5AF5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8DA7A39D-D3A0-8A11-56B9-863386AB3E65}"/>
              </a:ext>
            </a:extLst>
          </p:cNvPr>
          <p:cNvSpPr/>
          <p:nvPr/>
        </p:nvSpPr>
        <p:spPr>
          <a:xfrm>
            <a:off x="2329822" y="2042931"/>
            <a:ext cx="893135" cy="287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8F9E8D6-0901-9AAE-4583-346460DEE355}"/>
              </a:ext>
            </a:extLst>
          </p:cNvPr>
          <p:cNvSpPr/>
          <p:nvPr/>
        </p:nvSpPr>
        <p:spPr>
          <a:xfrm>
            <a:off x="2361722" y="4218826"/>
            <a:ext cx="937758" cy="5078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7E2F94D-A337-EB87-B834-A7C0AEAFB909}"/>
              </a:ext>
            </a:extLst>
          </p:cNvPr>
          <p:cNvSpPr txBox="1"/>
          <p:nvPr/>
        </p:nvSpPr>
        <p:spPr>
          <a:xfrm>
            <a:off x="2156150" y="6497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D-E</a:t>
            </a:r>
            <a:endParaRPr lang="en-US" b="1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414157B-1AD1-C073-E8C1-2089CB9F6E7A}"/>
              </a:ext>
            </a:extLst>
          </p:cNvPr>
          <p:cNvSpPr/>
          <p:nvPr/>
        </p:nvSpPr>
        <p:spPr>
          <a:xfrm>
            <a:off x="7776732" y="3853116"/>
            <a:ext cx="1001965" cy="291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C4B55EF-ECBF-C29C-7E96-343B01D5AEF2}"/>
              </a:ext>
            </a:extLst>
          </p:cNvPr>
          <p:cNvSpPr/>
          <p:nvPr/>
        </p:nvSpPr>
        <p:spPr>
          <a:xfrm>
            <a:off x="7776732" y="4695330"/>
            <a:ext cx="1001965" cy="2694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252992-CE51-A156-72F3-F54CA486AFDB}"/>
              </a:ext>
            </a:extLst>
          </p:cNvPr>
          <p:cNvSpPr txBox="1"/>
          <p:nvPr/>
        </p:nvSpPr>
        <p:spPr>
          <a:xfrm>
            <a:off x="7821128" y="48372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B-C</a:t>
            </a:r>
            <a:endParaRPr lang="en-US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1755DB4-0E2A-626A-285A-889C1D7BE014}"/>
              </a:ext>
            </a:extLst>
          </p:cNvPr>
          <p:cNvSpPr txBox="1"/>
          <p:nvPr/>
        </p:nvSpPr>
        <p:spPr>
          <a:xfrm>
            <a:off x="81036" y="6560507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19585700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Picture 36" descr="A picture containing text&#10;&#10;Description automatically generated">
            <a:extLst>
              <a:ext uri="{FF2B5EF4-FFF2-40B4-BE49-F238E27FC236}">
                <a16:creationId xmlns:a16="http://schemas.microsoft.com/office/drawing/2014/main" id="{0461820B-8C3D-98E3-36D9-5B444A6507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8500" y="3338907"/>
            <a:ext cx="3543300" cy="866775"/>
          </a:xfrm>
          <a:prstGeom prst="rect">
            <a:avLst/>
          </a:prstGeom>
        </p:spPr>
      </p:pic>
      <p:pic>
        <p:nvPicPr>
          <p:cNvPr id="27" name="Picture 26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325B9B82-7007-EB83-71B1-20ED1A5CE5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3797" y="1264524"/>
            <a:ext cx="3572190" cy="188403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E0F4B5C-4502-C918-7141-7784E2B7973B}"/>
              </a:ext>
            </a:extLst>
          </p:cNvPr>
          <p:cNvSpPr txBox="1"/>
          <p:nvPr/>
        </p:nvSpPr>
        <p:spPr>
          <a:xfrm>
            <a:off x="9636641" y="3500859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PAR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52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170EFA1-03A6-FCE0-B212-A03F29645BE1}"/>
              </a:ext>
            </a:extLst>
          </p:cNvPr>
          <p:cNvSpPr txBox="1"/>
          <p:nvPr/>
        </p:nvSpPr>
        <p:spPr>
          <a:xfrm>
            <a:off x="9535986" y="2315649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SL1 68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5EF61B-1EA9-46F4-B7A1-0742D9396B8B}"/>
              </a:ext>
            </a:extLst>
          </p:cNvPr>
          <p:cNvSpPr txBox="1"/>
          <p:nvPr/>
        </p:nvSpPr>
        <p:spPr>
          <a:xfrm>
            <a:off x="9636641" y="468982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A00E3C-F7B6-9BF5-12A6-20B603864BF4}"/>
              </a:ext>
            </a:extLst>
          </p:cNvPr>
          <p:cNvSpPr txBox="1"/>
          <p:nvPr/>
        </p:nvSpPr>
        <p:spPr>
          <a:xfrm>
            <a:off x="4011389" y="2582219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LXR</a:t>
            </a:r>
            <a:r>
              <a:rPr lang="en-US" dirty="0" err="1">
                <a:latin typeface="Symbol" panose="05050102010706020507" pitchFamily="18" charset="2"/>
              </a:rPr>
              <a:t>a</a:t>
            </a:r>
            <a:r>
              <a:rPr lang="en-US" dirty="0"/>
              <a:t> 50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0EDEDC-B244-06E9-5DEC-96A123D4ADB6}"/>
              </a:ext>
            </a:extLst>
          </p:cNvPr>
          <p:cNvSpPr txBox="1"/>
          <p:nvPr/>
        </p:nvSpPr>
        <p:spPr>
          <a:xfrm>
            <a:off x="4031725" y="4287436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808124B-892D-45E3-F100-5DDAE47AFD0E}"/>
              </a:ext>
            </a:extLst>
          </p:cNvPr>
          <p:cNvGrpSpPr/>
          <p:nvPr/>
        </p:nvGrpSpPr>
        <p:grpSpPr>
          <a:xfrm>
            <a:off x="1035478" y="1505304"/>
            <a:ext cx="3561704" cy="468754"/>
            <a:chOff x="970839" y="418953"/>
            <a:chExt cx="3561704" cy="468754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BDD01B5-D218-63D2-941D-FFD946316F1A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9035AFE-72E7-A66D-5E69-5C6FF5258576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54A6BCC-1C6A-9C1A-AA31-5BA93B716748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8DECED6-8190-D63D-9669-332F92381F23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758B7A6-F2C2-E8D3-56F0-3BB3F1CE66E8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50F2C68-0871-D034-533A-7AD363EF6F17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3C80F2B-8437-1971-0DDC-8AD8CEE44983}"/>
              </a:ext>
            </a:extLst>
          </p:cNvPr>
          <p:cNvGrpSpPr/>
          <p:nvPr/>
        </p:nvGrpSpPr>
        <p:grpSpPr>
          <a:xfrm>
            <a:off x="6096000" y="649182"/>
            <a:ext cx="3561704" cy="468754"/>
            <a:chOff x="970839" y="418953"/>
            <a:chExt cx="3561704" cy="468754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44AC0EA-744A-F402-A95D-AA6A00B43311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642C56B-9021-5809-32BA-889E84F397F8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412372E-7BC8-8DDC-D496-E42FA80E2636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3593FEE-FE1C-F555-92E6-F28529202F64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F1FDC82-0543-AA82-6249-E651326B08AB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D3CE4A1-EAFF-7FF1-D004-7793E86228A0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pic>
        <p:nvPicPr>
          <p:cNvPr id="24" name="Picture 23" descr="A picture containing text, indoor, close&#10;&#10;Description automatically generated">
            <a:extLst>
              <a:ext uri="{FF2B5EF4-FFF2-40B4-BE49-F238E27FC236}">
                <a16:creationId xmlns:a16="http://schemas.microsoft.com/office/drawing/2014/main" id="{602769B0-9024-2CCF-0E50-024EB265DB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611" y="3875507"/>
            <a:ext cx="3429000" cy="1990725"/>
          </a:xfrm>
          <a:prstGeom prst="rect">
            <a:avLst/>
          </a:prstGeom>
        </p:spPr>
      </p:pic>
      <p:pic>
        <p:nvPicPr>
          <p:cNvPr id="28" name="Picture 27" descr="A close up of a keyboard&#10;&#10;Description automatically generated with medium confidence">
            <a:extLst>
              <a:ext uri="{FF2B5EF4-FFF2-40B4-BE49-F238E27FC236}">
                <a16:creationId xmlns:a16="http://schemas.microsoft.com/office/drawing/2014/main" id="{82366072-5A32-3539-A720-DBD5141F6C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914" y="2197101"/>
            <a:ext cx="3419475" cy="1598364"/>
          </a:xfrm>
          <a:prstGeom prst="rect">
            <a:avLst/>
          </a:prstGeom>
        </p:spPr>
      </p:pic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6B1D633-AA49-7AF8-BB60-A376C3C04F70}"/>
              </a:ext>
            </a:extLst>
          </p:cNvPr>
          <p:cNvCxnSpPr/>
          <p:nvPr/>
        </p:nvCxnSpPr>
        <p:spPr>
          <a:xfrm>
            <a:off x="236516" y="2955028"/>
            <a:ext cx="89313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591F5F4-B079-D259-9725-F452B8DCE5CB}"/>
              </a:ext>
            </a:extLst>
          </p:cNvPr>
          <p:cNvSpPr txBox="1"/>
          <p:nvPr/>
        </p:nvSpPr>
        <p:spPr>
          <a:xfrm>
            <a:off x="1304133" y="5970336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pic>
        <p:nvPicPr>
          <p:cNvPr id="33" name="Picture 32" descr="A picture containing text, device, meter, close&#10;&#10;Description automatically generated">
            <a:extLst>
              <a:ext uri="{FF2B5EF4-FFF2-40B4-BE49-F238E27FC236}">
                <a16:creationId xmlns:a16="http://schemas.microsoft.com/office/drawing/2014/main" id="{59D91AF1-DC74-A619-A7BC-E07B5C40670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2686" y="4295541"/>
            <a:ext cx="3543300" cy="1828800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5BE4837-0099-8013-0848-04FE0F1AC224}"/>
              </a:ext>
            </a:extLst>
          </p:cNvPr>
          <p:cNvSpPr txBox="1"/>
          <p:nvPr/>
        </p:nvSpPr>
        <p:spPr>
          <a:xfrm>
            <a:off x="6722946" y="6155002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E7BF70EC-1D3C-D70F-4AB1-979EE8626B17}"/>
              </a:ext>
            </a:extLst>
          </p:cNvPr>
          <p:cNvCxnSpPr>
            <a:cxnSpLocks/>
          </p:cNvCxnSpPr>
          <p:nvPr/>
        </p:nvCxnSpPr>
        <p:spPr>
          <a:xfrm flipH="1">
            <a:off x="8726406" y="2743309"/>
            <a:ext cx="60499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E22F755C-C08C-971D-404D-BFFDAB726131}"/>
              </a:ext>
            </a:extLst>
          </p:cNvPr>
          <p:cNvSpPr/>
          <p:nvPr/>
        </p:nvSpPr>
        <p:spPr>
          <a:xfrm>
            <a:off x="6128472" y="3457875"/>
            <a:ext cx="902329" cy="5517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BCC0E3F-EDB8-FAF3-F804-27069349D1D9}"/>
              </a:ext>
            </a:extLst>
          </p:cNvPr>
          <p:cNvSpPr/>
          <p:nvPr/>
        </p:nvSpPr>
        <p:spPr>
          <a:xfrm>
            <a:off x="1960654" y="2747382"/>
            <a:ext cx="893135" cy="3630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1B3B54A-FC96-2CE6-D70A-5533F2149137}"/>
              </a:ext>
            </a:extLst>
          </p:cNvPr>
          <p:cNvSpPr/>
          <p:nvPr/>
        </p:nvSpPr>
        <p:spPr>
          <a:xfrm>
            <a:off x="7760378" y="2570565"/>
            <a:ext cx="865374" cy="369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753E09C-A6B4-7631-8783-838A4AFD995D}"/>
              </a:ext>
            </a:extLst>
          </p:cNvPr>
          <p:cNvSpPr txBox="1"/>
          <p:nvPr/>
        </p:nvSpPr>
        <p:spPr>
          <a:xfrm>
            <a:off x="3934853" y="2840032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B-C</a:t>
            </a:r>
            <a:endParaRPr lang="en-US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A20AC37-9FF3-9808-3D30-59F5F3DFAEC0}"/>
              </a:ext>
            </a:extLst>
          </p:cNvPr>
          <p:cNvSpPr txBox="1"/>
          <p:nvPr/>
        </p:nvSpPr>
        <p:spPr>
          <a:xfrm>
            <a:off x="9671772" y="3772294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B-C</a:t>
            </a:r>
            <a:endParaRPr lang="en-US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F3325A5-4BE6-4B1F-C340-A650D8645A70}"/>
              </a:ext>
            </a:extLst>
          </p:cNvPr>
          <p:cNvSpPr txBox="1"/>
          <p:nvPr/>
        </p:nvSpPr>
        <p:spPr>
          <a:xfrm>
            <a:off x="9594291" y="2626951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D-E</a:t>
            </a:r>
            <a:endParaRPr lang="en-US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860E0AE-E3FC-2458-F3DE-6CBEFB91817F}"/>
              </a:ext>
            </a:extLst>
          </p:cNvPr>
          <p:cNvSpPr txBox="1"/>
          <p:nvPr/>
        </p:nvSpPr>
        <p:spPr>
          <a:xfrm>
            <a:off x="438469" y="6395241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1730727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x&#10;&#10;Description automatically generated">
            <a:extLst>
              <a:ext uri="{FF2B5EF4-FFF2-40B4-BE49-F238E27FC236}">
                <a16:creationId xmlns:a16="http://schemas.microsoft.com/office/drawing/2014/main" id="{527B068C-FBB6-DC5F-6578-175BD450E0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415" y="3178469"/>
            <a:ext cx="3810000" cy="1819275"/>
          </a:xfrm>
          <a:prstGeom prst="rect">
            <a:avLst/>
          </a:prstGeom>
        </p:spPr>
      </p:pic>
      <p:pic>
        <p:nvPicPr>
          <p:cNvPr id="5" name="Picture 4" descr="A picture containing text, outdoor, image&#10;&#10;Description automatically generated">
            <a:extLst>
              <a:ext uri="{FF2B5EF4-FFF2-40B4-BE49-F238E27FC236}">
                <a16:creationId xmlns:a16="http://schemas.microsoft.com/office/drawing/2014/main" id="{D12EED29-FCF6-2765-35CF-86F99B0A72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525" y="817045"/>
            <a:ext cx="3800475" cy="1819275"/>
          </a:xfrm>
          <a:prstGeom prst="rect">
            <a:avLst/>
          </a:prstGeom>
        </p:spPr>
      </p:pic>
      <p:pic>
        <p:nvPicPr>
          <p:cNvPr id="9" name="Picture 8" descr="A close-up of a note&#10;&#10;Description automatically generated with low confidence">
            <a:extLst>
              <a:ext uri="{FF2B5EF4-FFF2-40B4-BE49-F238E27FC236}">
                <a16:creationId xmlns:a16="http://schemas.microsoft.com/office/drawing/2014/main" id="{F435E23E-96DC-3192-44C4-B7D3B21FE5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7980" y="1226422"/>
            <a:ext cx="3781425" cy="267652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391EF99-9B5B-A9FF-3999-1B022B0C688D}"/>
              </a:ext>
            </a:extLst>
          </p:cNvPr>
          <p:cNvSpPr txBox="1"/>
          <p:nvPr/>
        </p:nvSpPr>
        <p:spPr>
          <a:xfrm>
            <a:off x="1672612" y="4997744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% Tris glycine ge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E462DB-F9F4-BEF3-9875-4789BDB7643E}"/>
              </a:ext>
            </a:extLst>
          </p:cNvPr>
          <p:cNvSpPr txBox="1"/>
          <p:nvPr/>
        </p:nvSpPr>
        <p:spPr>
          <a:xfrm>
            <a:off x="7719631" y="3898380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Tris glycine ge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AB6BA68-DAA8-48BC-21A0-53ECCD26BBB6}"/>
              </a:ext>
            </a:extLst>
          </p:cNvPr>
          <p:cNvSpPr txBox="1"/>
          <p:nvPr/>
        </p:nvSpPr>
        <p:spPr>
          <a:xfrm>
            <a:off x="10417009" y="2054922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LXR</a:t>
            </a:r>
            <a:r>
              <a:rPr lang="en-US" altLang="zh-CN" dirty="0" err="1">
                <a:latin typeface="Symbol" panose="05050102010706020507" pitchFamily="18" charset="2"/>
              </a:rPr>
              <a:t>b</a:t>
            </a:r>
            <a:r>
              <a:rPr lang="en-US" dirty="0"/>
              <a:t>  51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FD4B8E-118D-5F11-EA7B-F8BD48A26B91}"/>
              </a:ext>
            </a:extLst>
          </p:cNvPr>
          <p:cNvSpPr txBox="1"/>
          <p:nvPr/>
        </p:nvSpPr>
        <p:spPr>
          <a:xfrm>
            <a:off x="4144305" y="1851859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OAT2  46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873A967-0B3F-14E0-1A7F-7822C84A52B9}"/>
              </a:ext>
            </a:extLst>
          </p:cNvPr>
          <p:cNvSpPr txBox="1"/>
          <p:nvPr/>
        </p:nvSpPr>
        <p:spPr>
          <a:xfrm>
            <a:off x="4211045" y="3594044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ABP4  15kDa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0CE84673-ACED-5676-E7BD-36934E073AF6}"/>
              </a:ext>
            </a:extLst>
          </p:cNvPr>
          <p:cNvGrpSpPr/>
          <p:nvPr/>
        </p:nvGrpSpPr>
        <p:grpSpPr>
          <a:xfrm>
            <a:off x="1273151" y="442841"/>
            <a:ext cx="3561704" cy="468754"/>
            <a:chOff x="970839" y="418953"/>
            <a:chExt cx="3561704" cy="468754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C12C3D9-EA9D-678A-EB75-7C56979BE6D0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AA909AA-6BBC-EA97-52BF-41372D3B0E74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20C717F-1670-9B06-49DC-A91A3BA5AA00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8165D84-15BE-533A-88AD-ACCDE012875F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C48DF59-C14F-B38E-455C-1C090BE33C1B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82F89EA-C3A1-35DD-352C-5F2FA66B5C13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F8B1AB8A-6C83-E599-4D9E-BD8C8C9DD276}"/>
              </a:ext>
            </a:extLst>
          </p:cNvPr>
          <p:cNvGrpSpPr/>
          <p:nvPr/>
        </p:nvGrpSpPr>
        <p:grpSpPr>
          <a:xfrm>
            <a:off x="7333097" y="1200789"/>
            <a:ext cx="3561704" cy="468754"/>
            <a:chOff x="970839" y="418953"/>
            <a:chExt cx="3561704" cy="468754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26EBF7B-9D70-0221-6EEA-89B930973A20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E14BD06-604B-622A-A57E-919042CEA475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9E0AF83-1208-17A9-0007-BB530DAF2D62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C96FB9E-EAF0-2363-93A8-902B8CA1D5BF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09CA0C8-6091-0585-A12F-8E6ED61F502D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D6EABFE-9429-FC1E-7CCD-5F76EF9A0B75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809BF462-B8CA-C77A-847C-C00C99841D7F}"/>
              </a:ext>
            </a:extLst>
          </p:cNvPr>
          <p:cNvSpPr/>
          <p:nvPr/>
        </p:nvSpPr>
        <p:spPr>
          <a:xfrm>
            <a:off x="9196031" y="2054922"/>
            <a:ext cx="1001965" cy="58139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C7CB66E-137B-E2BC-EB9A-676C9076EF9A}"/>
              </a:ext>
            </a:extLst>
          </p:cNvPr>
          <p:cNvSpPr/>
          <p:nvPr/>
        </p:nvSpPr>
        <p:spPr>
          <a:xfrm>
            <a:off x="2240001" y="1967015"/>
            <a:ext cx="831357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C2FFC67-940B-FBF7-0C2F-2F93586B9268}"/>
              </a:ext>
            </a:extLst>
          </p:cNvPr>
          <p:cNvSpPr/>
          <p:nvPr/>
        </p:nvSpPr>
        <p:spPr>
          <a:xfrm>
            <a:off x="2240001" y="3594044"/>
            <a:ext cx="831357" cy="47744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1EE5E5-1D7F-0933-FD69-6EFC73DECCAC}"/>
              </a:ext>
            </a:extLst>
          </p:cNvPr>
          <p:cNvSpPr txBox="1"/>
          <p:nvPr/>
        </p:nvSpPr>
        <p:spPr>
          <a:xfrm>
            <a:off x="4218777" y="3870093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D-E</a:t>
            </a:r>
            <a:endParaRPr lang="en-US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3772D9-B3A5-D360-308D-605A571744A0}"/>
              </a:ext>
            </a:extLst>
          </p:cNvPr>
          <p:cNvSpPr txBox="1"/>
          <p:nvPr/>
        </p:nvSpPr>
        <p:spPr>
          <a:xfrm>
            <a:off x="4138050" y="2203410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B-C</a:t>
            </a:r>
            <a:endParaRPr lang="en-US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784E2B-2A59-E622-CA37-691620DCC18B}"/>
              </a:ext>
            </a:extLst>
          </p:cNvPr>
          <p:cNvSpPr txBox="1"/>
          <p:nvPr/>
        </p:nvSpPr>
        <p:spPr>
          <a:xfrm>
            <a:off x="10395098" y="2389661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B-C</a:t>
            </a:r>
            <a:endParaRPr lang="en-US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98E99D2-5A21-F666-BE1E-84A08488D0F1}"/>
              </a:ext>
            </a:extLst>
          </p:cNvPr>
          <p:cNvSpPr txBox="1"/>
          <p:nvPr/>
        </p:nvSpPr>
        <p:spPr>
          <a:xfrm>
            <a:off x="431689" y="6262721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734167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857B71-E308-D951-4D6E-E6E38550C9D1}"/>
              </a:ext>
            </a:extLst>
          </p:cNvPr>
          <p:cNvSpPr txBox="1"/>
          <p:nvPr/>
        </p:nvSpPr>
        <p:spPr>
          <a:xfrm>
            <a:off x="1647646" y="5686504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5A62200-A6B3-16B3-E060-15AD7B43B03A}"/>
              </a:ext>
            </a:extLst>
          </p:cNvPr>
          <p:cNvSpPr txBox="1"/>
          <p:nvPr/>
        </p:nvSpPr>
        <p:spPr>
          <a:xfrm>
            <a:off x="7957711" y="5966286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% Tris glycine gel</a:t>
            </a:r>
          </a:p>
        </p:txBody>
      </p:sp>
      <p:pic>
        <p:nvPicPr>
          <p:cNvPr id="5" name="Picture 4" descr="A picture containing text, close, image&#10;&#10;Description automatically generated">
            <a:extLst>
              <a:ext uri="{FF2B5EF4-FFF2-40B4-BE49-F238E27FC236}">
                <a16:creationId xmlns:a16="http://schemas.microsoft.com/office/drawing/2014/main" id="{E73BC28E-5196-F2DB-4FDF-F573EBACEB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346" y="3946750"/>
            <a:ext cx="4171950" cy="1609725"/>
          </a:xfrm>
          <a:prstGeom prst="rect">
            <a:avLst/>
          </a:prstGeom>
        </p:spPr>
      </p:pic>
      <p:pic>
        <p:nvPicPr>
          <p:cNvPr id="7" name="Picture 6" descr="A close up of a cell phone&#10;&#10;Description automatically generated with low confidence">
            <a:extLst>
              <a:ext uri="{FF2B5EF4-FFF2-40B4-BE49-F238E27FC236}">
                <a16:creationId xmlns:a16="http://schemas.microsoft.com/office/drawing/2014/main" id="{0C4B9832-7848-2E58-8483-92BEE5F3E3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96" y="1614899"/>
            <a:ext cx="4162425" cy="1362075"/>
          </a:xfrm>
          <a:prstGeom prst="rect">
            <a:avLst/>
          </a:prstGeom>
        </p:spPr>
      </p:pic>
      <p:pic>
        <p:nvPicPr>
          <p:cNvPr id="9" name="Picture 8" descr="A close up of a cell phone&#10;&#10;Description automatically generated with low confidence">
            <a:extLst>
              <a:ext uri="{FF2B5EF4-FFF2-40B4-BE49-F238E27FC236}">
                <a16:creationId xmlns:a16="http://schemas.microsoft.com/office/drawing/2014/main" id="{1999085A-64E6-B57B-C3E4-AC35ACF1D4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871" y="3014187"/>
            <a:ext cx="4171950" cy="895350"/>
          </a:xfrm>
          <a:prstGeom prst="rect">
            <a:avLst/>
          </a:prstGeom>
        </p:spPr>
      </p:pic>
      <p:pic>
        <p:nvPicPr>
          <p:cNvPr id="11" name="Picture 10" descr="A picture containing text, close&#10;&#10;Description automatically generated">
            <a:extLst>
              <a:ext uri="{FF2B5EF4-FFF2-40B4-BE49-F238E27FC236}">
                <a16:creationId xmlns:a16="http://schemas.microsoft.com/office/drawing/2014/main" id="{5FBD484D-21F2-6BCE-184E-0B5C2CB47D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9094" y="3909537"/>
            <a:ext cx="4133850" cy="1514475"/>
          </a:xfrm>
          <a:prstGeom prst="rect">
            <a:avLst/>
          </a:prstGeom>
        </p:spPr>
      </p:pic>
      <p:pic>
        <p:nvPicPr>
          <p:cNvPr id="13" name="Picture 12" descr="A picture containing text, indoor, close&#10;&#10;Description automatically generated">
            <a:extLst>
              <a:ext uri="{FF2B5EF4-FFF2-40B4-BE49-F238E27FC236}">
                <a16:creationId xmlns:a16="http://schemas.microsoft.com/office/drawing/2014/main" id="{C994760E-7018-8017-888D-ABD3D2AE4BE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9094" y="1649710"/>
            <a:ext cx="4181475" cy="2019300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F311EE6C-498C-9E94-363E-35FEF7E91482}"/>
              </a:ext>
            </a:extLst>
          </p:cNvPr>
          <p:cNvGrpSpPr/>
          <p:nvPr/>
        </p:nvGrpSpPr>
        <p:grpSpPr>
          <a:xfrm>
            <a:off x="1275686" y="1504836"/>
            <a:ext cx="3561704" cy="468754"/>
            <a:chOff x="970839" y="418953"/>
            <a:chExt cx="3561704" cy="46875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5DB530E-4604-9304-9BD1-33A994A1A79F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299CC0F-BA0B-5762-62FA-6F8B08310AF6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D67D78E-F3E6-257A-5124-E63DBC2E2812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B6FE355-67EE-8616-4C74-8DFBD830215E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340DED-5E8B-6D5C-B31C-48DA57920582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FDE374A-64CD-32E9-D12C-C40DD9CE0412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FD35886-526B-B595-69AA-F8E093393928}"/>
              </a:ext>
            </a:extLst>
          </p:cNvPr>
          <p:cNvGrpSpPr/>
          <p:nvPr/>
        </p:nvGrpSpPr>
        <p:grpSpPr>
          <a:xfrm>
            <a:off x="7028979" y="1295070"/>
            <a:ext cx="3561704" cy="468754"/>
            <a:chOff x="970839" y="418953"/>
            <a:chExt cx="3561704" cy="46875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8D561E4-C374-3F7A-9B4E-5B4646AD3C76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4D58ED5-A886-B8A6-4301-6F52D5D3C2D9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E99620C-C351-4137-CA20-795392C79FD1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A4647C1-6D59-B7E8-227D-248F627F9251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7F9B43A-32C2-04E2-14E3-CD20EFDE9200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82CC7C0-B692-012E-A135-9E141B886BC4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A4E29620-EC28-ADD7-0C9D-A25FB9F5C43F}"/>
              </a:ext>
            </a:extLst>
          </p:cNvPr>
          <p:cNvSpPr txBox="1"/>
          <p:nvPr/>
        </p:nvSpPr>
        <p:spPr>
          <a:xfrm>
            <a:off x="4268900" y="2658118"/>
            <a:ext cx="1838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PT2  65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4607B73-4DD6-0F8B-E778-3A4CC6AD315E}"/>
              </a:ext>
            </a:extLst>
          </p:cNvPr>
          <p:cNvSpPr txBox="1"/>
          <p:nvPr/>
        </p:nvSpPr>
        <p:spPr>
          <a:xfrm>
            <a:off x="4316381" y="3181940"/>
            <a:ext cx="2032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PAR</a:t>
            </a:r>
            <a:r>
              <a:rPr lang="en-US" dirty="0" err="1">
                <a:latin typeface="Symbol" panose="05050102010706020507" pitchFamily="18" charset="2"/>
              </a:rPr>
              <a:t>b</a:t>
            </a:r>
            <a:r>
              <a:rPr lang="en-US" dirty="0"/>
              <a:t>/</a:t>
            </a:r>
            <a:r>
              <a:rPr lang="en-US" dirty="0">
                <a:latin typeface="Symbol" panose="05050102010706020507" pitchFamily="18" charset="2"/>
              </a:rPr>
              <a:t>d  </a:t>
            </a:r>
            <a:r>
              <a:rPr lang="en-US" dirty="0"/>
              <a:t>54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EBA1798-3D7D-E1BB-455D-ED79AFA63527}"/>
              </a:ext>
            </a:extLst>
          </p:cNvPr>
          <p:cNvSpPr txBox="1"/>
          <p:nvPr/>
        </p:nvSpPr>
        <p:spPr>
          <a:xfrm>
            <a:off x="4316381" y="4252343"/>
            <a:ext cx="2231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ADM  43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55961F8-59F1-1345-0C64-E0A6FEC953FA}"/>
              </a:ext>
            </a:extLst>
          </p:cNvPr>
          <p:cNvSpPr txBox="1"/>
          <p:nvPr/>
        </p:nvSpPr>
        <p:spPr>
          <a:xfrm>
            <a:off x="10559983" y="310448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36  53kDa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5C23AA09-569D-A73B-4DA7-E4A99A86BF0D}"/>
              </a:ext>
            </a:extLst>
          </p:cNvPr>
          <p:cNvCxnSpPr>
            <a:cxnSpLocks/>
          </p:cNvCxnSpPr>
          <p:nvPr/>
        </p:nvCxnSpPr>
        <p:spPr>
          <a:xfrm flipH="1">
            <a:off x="9961067" y="3291949"/>
            <a:ext cx="60499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4556983-57B7-6553-734C-A9E92EC5DA5B}"/>
              </a:ext>
            </a:extLst>
          </p:cNvPr>
          <p:cNvSpPr txBox="1"/>
          <p:nvPr/>
        </p:nvSpPr>
        <p:spPr>
          <a:xfrm>
            <a:off x="10527270" y="425234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89194AD-5B78-3868-513E-47C94D980483}"/>
              </a:ext>
            </a:extLst>
          </p:cNvPr>
          <p:cNvSpPr/>
          <p:nvPr/>
        </p:nvSpPr>
        <p:spPr>
          <a:xfrm>
            <a:off x="3202826" y="3259708"/>
            <a:ext cx="1066073" cy="4093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1FEBDBC-A153-7215-CE3B-A9CD5BFB67BC}"/>
              </a:ext>
            </a:extLst>
          </p:cNvPr>
          <p:cNvSpPr/>
          <p:nvPr/>
        </p:nvSpPr>
        <p:spPr>
          <a:xfrm>
            <a:off x="2280321" y="2638839"/>
            <a:ext cx="914400" cy="34137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557B0A0-158A-CD84-4C1F-BE5861AEAB71}"/>
              </a:ext>
            </a:extLst>
          </p:cNvPr>
          <p:cNvSpPr/>
          <p:nvPr/>
        </p:nvSpPr>
        <p:spPr>
          <a:xfrm>
            <a:off x="8117589" y="4710223"/>
            <a:ext cx="902329" cy="49806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9FC964E-5D8F-B1A8-BE3B-D8EC2525C853}"/>
              </a:ext>
            </a:extLst>
          </p:cNvPr>
          <p:cNvSpPr/>
          <p:nvPr/>
        </p:nvSpPr>
        <p:spPr>
          <a:xfrm>
            <a:off x="8052090" y="3181940"/>
            <a:ext cx="904030" cy="36932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D34FD0B-F2C7-046F-94C4-252718CE721D}"/>
              </a:ext>
            </a:extLst>
          </p:cNvPr>
          <p:cNvSpPr/>
          <p:nvPr/>
        </p:nvSpPr>
        <p:spPr>
          <a:xfrm>
            <a:off x="1298533" y="4252343"/>
            <a:ext cx="981788" cy="45788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0AAEB0-BFE0-BD1A-03B9-22E7630FB718}"/>
              </a:ext>
            </a:extLst>
          </p:cNvPr>
          <p:cNvSpPr txBox="1"/>
          <p:nvPr/>
        </p:nvSpPr>
        <p:spPr>
          <a:xfrm>
            <a:off x="8072521" y="587092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D-E</a:t>
            </a:r>
            <a:endParaRPr lang="en-US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6D8C46D-B83E-5866-5E90-D101F33B468D}"/>
              </a:ext>
            </a:extLst>
          </p:cNvPr>
          <p:cNvSpPr txBox="1"/>
          <p:nvPr/>
        </p:nvSpPr>
        <p:spPr>
          <a:xfrm>
            <a:off x="4289538" y="2378817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D-E</a:t>
            </a:r>
            <a:endParaRPr lang="en-US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C5693AB-E328-5DE9-09F2-587B05346864}"/>
              </a:ext>
            </a:extLst>
          </p:cNvPr>
          <p:cNvSpPr txBox="1"/>
          <p:nvPr/>
        </p:nvSpPr>
        <p:spPr>
          <a:xfrm>
            <a:off x="4366296" y="3411549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B-C</a:t>
            </a:r>
            <a:endParaRPr lang="en-US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3A54141-19AF-96E1-A502-AB064C02BAD3}"/>
              </a:ext>
            </a:extLst>
          </p:cNvPr>
          <p:cNvSpPr txBox="1"/>
          <p:nvPr/>
        </p:nvSpPr>
        <p:spPr>
          <a:xfrm>
            <a:off x="4357950" y="4525557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3D-E</a:t>
            </a:r>
            <a:endParaRPr lang="en-US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3DB3481-4155-1302-9AAF-7B44712B1B39}"/>
              </a:ext>
            </a:extLst>
          </p:cNvPr>
          <p:cNvSpPr txBox="1"/>
          <p:nvPr/>
        </p:nvSpPr>
        <p:spPr>
          <a:xfrm>
            <a:off x="416480" y="6398642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12768570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C507E163-A5DD-FD66-D643-FB01619F2F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778" y="4495801"/>
            <a:ext cx="3648075" cy="1685925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FEB07D48-7E7C-3820-E8E3-880F14729A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352" y="1196818"/>
            <a:ext cx="3638550" cy="1600200"/>
          </a:xfrm>
          <a:prstGeom prst="rect">
            <a:avLst/>
          </a:prstGeom>
        </p:spPr>
      </p:pic>
      <p:pic>
        <p:nvPicPr>
          <p:cNvPr id="7" name="Picture 6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0E0B65AA-D3DC-2DDF-002F-8CDE8C84D3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352" y="2875478"/>
            <a:ext cx="3648075" cy="1476375"/>
          </a:xfrm>
          <a:prstGeom prst="rect">
            <a:avLst/>
          </a:prstGeo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6CAD9A7A-DA99-C4CE-1B95-0E51109E75C9}"/>
              </a:ext>
            </a:extLst>
          </p:cNvPr>
          <p:cNvGrpSpPr/>
          <p:nvPr/>
        </p:nvGrpSpPr>
        <p:grpSpPr>
          <a:xfrm>
            <a:off x="992452" y="624480"/>
            <a:ext cx="3561704" cy="468754"/>
            <a:chOff x="970839" y="418953"/>
            <a:chExt cx="3561704" cy="468754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C0235A0-58C0-77CA-2567-1A4E3CB58548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FA5AE46-D127-EF8E-7CAB-ED78ABD1DAE0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52FC19-7339-D2A4-AF91-F3004C728FEA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7FFA476-3757-CECB-B205-BAAB20E198CB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3B1751E-A750-A5BF-19BE-F34E28BFA3FF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6021F15-9479-743D-AA39-5558C620802E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492C9FA5-BC30-45CD-D865-89A4627D669F}"/>
              </a:ext>
            </a:extLst>
          </p:cNvPr>
          <p:cNvSpPr txBox="1"/>
          <p:nvPr/>
        </p:nvSpPr>
        <p:spPr>
          <a:xfrm>
            <a:off x="4172900" y="1895696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GS1 63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9C742BA-0261-E73A-DF29-68A1F5898BD7}"/>
              </a:ext>
            </a:extLst>
          </p:cNvPr>
          <p:cNvSpPr txBox="1"/>
          <p:nvPr/>
        </p:nvSpPr>
        <p:spPr>
          <a:xfrm>
            <a:off x="4172901" y="321004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FFAZIN 35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53BF35E-5880-608B-9816-66C07B68464F}"/>
              </a:ext>
            </a:extLst>
          </p:cNvPr>
          <p:cNvSpPr txBox="1"/>
          <p:nvPr/>
        </p:nvSpPr>
        <p:spPr>
          <a:xfrm>
            <a:off x="4172902" y="5338763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X IV 17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0E2C20-39F8-6652-B0B8-C69D8FD57CF9}"/>
              </a:ext>
            </a:extLst>
          </p:cNvPr>
          <p:cNvSpPr txBox="1"/>
          <p:nvPr/>
        </p:nvSpPr>
        <p:spPr>
          <a:xfrm>
            <a:off x="1619398" y="6016138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% Tris glycine gel</a:t>
            </a:r>
          </a:p>
        </p:txBody>
      </p:sp>
      <p:pic>
        <p:nvPicPr>
          <p:cNvPr id="20" name="Picture 19" descr="A picture containing text, day&#10;&#10;Description automatically generated">
            <a:extLst>
              <a:ext uri="{FF2B5EF4-FFF2-40B4-BE49-F238E27FC236}">
                <a16:creationId xmlns:a16="http://schemas.microsoft.com/office/drawing/2014/main" id="{0B97AFF7-E928-0FEE-EDE2-1BE4B2F8AC9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6159" y="5203270"/>
            <a:ext cx="3638550" cy="1009650"/>
          </a:xfrm>
          <a:prstGeom prst="rect">
            <a:avLst/>
          </a:prstGeom>
        </p:spPr>
      </p:pic>
      <p:pic>
        <p:nvPicPr>
          <p:cNvPr id="22" name="Picture 21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09E173F0-0490-816C-CE14-AEB6158B711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6159" y="1196818"/>
            <a:ext cx="3638550" cy="1885950"/>
          </a:xfrm>
          <a:prstGeom prst="rect">
            <a:avLst/>
          </a:prstGeom>
        </p:spPr>
      </p:pic>
      <p:pic>
        <p:nvPicPr>
          <p:cNvPr id="24" name="Picture 23" descr="A picture containing text&#10;&#10;Description automatically generated">
            <a:extLst>
              <a:ext uri="{FF2B5EF4-FFF2-40B4-BE49-F238E27FC236}">
                <a16:creationId xmlns:a16="http://schemas.microsoft.com/office/drawing/2014/main" id="{2019F678-8C42-3976-8842-74698F36946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6159" y="3163427"/>
            <a:ext cx="3638550" cy="188595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9BA0AF3-3F52-C48F-05B4-D1D1BDDF44E0}"/>
              </a:ext>
            </a:extLst>
          </p:cNvPr>
          <p:cNvSpPr txBox="1"/>
          <p:nvPr/>
        </p:nvSpPr>
        <p:spPr>
          <a:xfrm>
            <a:off x="7687787" y="6165620"/>
            <a:ext cx="1991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% Tris glycine ge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16A709F-E02F-DFB6-5F22-499732270E7A}"/>
              </a:ext>
            </a:extLst>
          </p:cNvPr>
          <p:cNvSpPr txBox="1"/>
          <p:nvPr/>
        </p:nvSpPr>
        <p:spPr>
          <a:xfrm>
            <a:off x="10218054" y="5154097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X IV 17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E8C3837-9DFE-BDDD-9E1B-6564319EDA31}"/>
              </a:ext>
            </a:extLst>
          </p:cNvPr>
          <p:cNvSpPr txBox="1"/>
          <p:nvPr/>
        </p:nvSpPr>
        <p:spPr>
          <a:xfrm>
            <a:off x="10130411" y="4560265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TPMT1 23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851751C-58B6-94C8-32B0-5779EBAAA85C}"/>
              </a:ext>
            </a:extLst>
          </p:cNvPr>
          <p:cNvSpPr txBox="1"/>
          <p:nvPr/>
        </p:nvSpPr>
        <p:spPr>
          <a:xfrm>
            <a:off x="10230835" y="2434480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LS1 </a:t>
            </a:r>
            <a:r>
              <a:rPr lang="en-US" altLang="zh-CN" dirty="0"/>
              <a:t>50</a:t>
            </a:r>
            <a:r>
              <a:rPr lang="en-US" dirty="0"/>
              <a:t>kDa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807E8CA-E66D-2932-92A1-DAD952B39152}"/>
              </a:ext>
            </a:extLst>
          </p:cNvPr>
          <p:cNvGrpSpPr/>
          <p:nvPr/>
        </p:nvGrpSpPr>
        <p:grpSpPr>
          <a:xfrm>
            <a:off x="6821752" y="624480"/>
            <a:ext cx="3561704" cy="468754"/>
            <a:chOff x="970839" y="418953"/>
            <a:chExt cx="3561704" cy="468754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13C2445-9819-72D4-DC44-7E41E2F6A5FC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02FF0E1-DB31-DA02-86FE-06CE859718A3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08AF0EF-02F7-4A43-6C7A-D8AC61185181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4363833-90AB-A494-4D64-044C37086825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FFE4304-C1A8-B78F-7F92-15F2FA7F93EC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2630CD0-FBC2-84DF-9A8F-A94ECC6E9534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3E0AF51C-56D8-756C-733A-F3538A1725EF}"/>
              </a:ext>
            </a:extLst>
          </p:cNvPr>
          <p:cNvSpPr txBox="1"/>
          <p:nvPr/>
        </p:nvSpPr>
        <p:spPr>
          <a:xfrm>
            <a:off x="4513683" y="118200"/>
            <a:ext cx="3467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itochondrial protein sample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58C3164-72F4-FF3F-69B3-8898F6B68E56}"/>
              </a:ext>
            </a:extLst>
          </p:cNvPr>
          <p:cNvSpPr/>
          <p:nvPr/>
        </p:nvSpPr>
        <p:spPr>
          <a:xfrm>
            <a:off x="1106905" y="1895696"/>
            <a:ext cx="910359" cy="4287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5D3BEC9-0726-1942-6B59-6315FBD7DA78}"/>
              </a:ext>
            </a:extLst>
          </p:cNvPr>
          <p:cNvSpPr/>
          <p:nvPr/>
        </p:nvSpPr>
        <p:spPr>
          <a:xfrm>
            <a:off x="6718434" y="4649002"/>
            <a:ext cx="969353" cy="400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026C155-CC15-918B-F4DA-4134281B68C4}"/>
              </a:ext>
            </a:extLst>
          </p:cNvPr>
          <p:cNvSpPr/>
          <p:nvPr/>
        </p:nvSpPr>
        <p:spPr>
          <a:xfrm>
            <a:off x="6718434" y="2324488"/>
            <a:ext cx="1028494" cy="4725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B8E3D64-14E6-E65F-29A9-E5D5824BE021}"/>
              </a:ext>
            </a:extLst>
          </p:cNvPr>
          <p:cNvSpPr/>
          <p:nvPr/>
        </p:nvSpPr>
        <p:spPr>
          <a:xfrm>
            <a:off x="1106905" y="3318933"/>
            <a:ext cx="841333" cy="3945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405A7FD-2681-0BCA-94EB-6FFF953C84F4}"/>
              </a:ext>
            </a:extLst>
          </p:cNvPr>
          <p:cNvSpPr/>
          <p:nvPr/>
        </p:nvSpPr>
        <p:spPr>
          <a:xfrm>
            <a:off x="6718434" y="5203270"/>
            <a:ext cx="1028494" cy="400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87E6C69-C98F-4163-4F07-23609630DD26}"/>
              </a:ext>
            </a:extLst>
          </p:cNvPr>
          <p:cNvSpPr txBox="1"/>
          <p:nvPr/>
        </p:nvSpPr>
        <p:spPr>
          <a:xfrm>
            <a:off x="5103576" y="475538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7B-C</a:t>
            </a:r>
            <a:endParaRPr lang="en-US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F9EF141-C360-A92A-DAE5-0C95A76262CA}"/>
              </a:ext>
            </a:extLst>
          </p:cNvPr>
          <p:cNvSpPr txBox="1"/>
          <p:nvPr/>
        </p:nvSpPr>
        <p:spPr>
          <a:xfrm>
            <a:off x="366316" y="6488668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</p:spTree>
    <p:extLst>
      <p:ext uri="{BB962C8B-B14F-4D97-AF65-F5344CB8AC3E}">
        <p14:creationId xmlns:p14="http://schemas.microsoft.com/office/powerpoint/2010/main" val="10482578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3DB7119-DB9F-B9AB-B56C-5672895190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2489" y="1522836"/>
            <a:ext cx="3322608" cy="120101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DE40764-7320-C07C-AB47-5AF56A8F84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2489" y="2965088"/>
            <a:ext cx="3316511" cy="163387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2280578-4705-C6D6-4DBB-42CDCA18F2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36526" y="1522836"/>
            <a:ext cx="3426249" cy="100592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F7C4FF3-405A-3510-6D02-726B829BAD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36525" y="2637548"/>
            <a:ext cx="3426249" cy="131075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86E97A4-1859-8BCE-D6C0-A8179073F7F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36524" y="4058562"/>
            <a:ext cx="3426249" cy="1719221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30F263C9-CAFB-FD3C-CB67-66512E438270}"/>
              </a:ext>
            </a:extLst>
          </p:cNvPr>
          <p:cNvCxnSpPr/>
          <p:nvPr/>
        </p:nvCxnSpPr>
        <p:spPr>
          <a:xfrm>
            <a:off x="1292489" y="2125451"/>
            <a:ext cx="55289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1854BED-78C3-53E9-A481-1DF096FDD309}"/>
              </a:ext>
            </a:extLst>
          </p:cNvPr>
          <p:cNvCxnSpPr/>
          <p:nvPr/>
        </p:nvCxnSpPr>
        <p:spPr>
          <a:xfrm>
            <a:off x="6632486" y="3039851"/>
            <a:ext cx="55289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76CCE23-9147-E508-B232-041BC0DC9ECF}"/>
              </a:ext>
            </a:extLst>
          </p:cNvPr>
          <p:cNvCxnSpPr/>
          <p:nvPr/>
        </p:nvCxnSpPr>
        <p:spPr>
          <a:xfrm>
            <a:off x="6632486" y="1689516"/>
            <a:ext cx="55289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F321B358-FD55-F3D1-C7CD-F6056345D268}"/>
              </a:ext>
            </a:extLst>
          </p:cNvPr>
          <p:cNvSpPr/>
          <p:nvPr/>
        </p:nvSpPr>
        <p:spPr>
          <a:xfrm>
            <a:off x="2695067" y="3958934"/>
            <a:ext cx="850604" cy="4146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0E5A99C-BD60-1E21-8C02-0ECD8790EF0F}"/>
              </a:ext>
            </a:extLst>
          </p:cNvPr>
          <p:cNvSpPr/>
          <p:nvPr/>
        </p:nvSpPr>
        <p:spPr>
          <a:xfrm>
            <a:off x="8101062" y="2847840"/>
            <a:ext cx="850604" cy="4146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6833DC4-0284-A33B-D48F-DDC8086AA1D6}"/>
              </a:ext>
            </a:extLst>
          </p:cNvPr>
          <p:cNvSpPr/>
          <p:nvPr/>
        </p:nvSpPr>
        <p:spPr>
          <a:xfrm>
            <a:off x="2695067" y="1960919"/>
            <a:ext cx="850604" cy="4146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628471A-7702-C579-E113-44021B3E703D}"/>
              </a:ext>
            </a:extLst>
          </p:cNvPr>
          <p:cNvSpPr/>
          <p:nvPr/>
        </p:nvSpPr>
        <p:spPr>
          <a:xfrm>
            <a:off x="8287257" y="1546257"/>
            <a:ext cx="850604" cy="4146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9FB9121E-BCE7-B96C-8054-49D978E544CA}"/>
              </a:ext>
            </a:extLst>
          </p:cNvPr>
          <p:cNvGrpSpPr/>
          <p:nvPr/>
        </p:nvGrpSpPr>
        <p:grpSpPr>
          <a:xfrm>
            <a:off x="1653078" y="893765"/>
            <a:ext cx="3561704" cy="468754"/>
            <a:chOff x="970839" y="418953"/>
            <a:chExt cx="3561704" cy="468754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2EA7F3A-D149-6C47-0651-47D53AB96B88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7CEF1A2-CA88-1B41-5BDB-9D36C0FE54B8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12C1D42-A554-F281-536F-053C3B524469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A16ECC1-5A07-B756-27DB-351B522B3A18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BB775E4-9E81-2ACD-4020-57ABE5BD69C3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27D8259-6B0A-4C4E-7756-129F16FE5FD7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CF34004-A20F-8CE7-71B7-90F5A5354C75}"/>
              </a:ext>
            </a:extLst>
          </p:cNvPr>
          <p:cNvGrpSpPr/>
          <p:nvPr/>
        </p:nvGrpSpPr>
        <p:grpSpPr>
          <a:xfrm>
            <a:off x="7185382" y="844054"/>
            <a:ext cx="3561704" cy="468754"/>
            <a:chOff x="970839" y="418953"/>
            <a:chExt cx="3561704" cy="468754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E3B5690-D96F-C752-432E-476EA9D7D8BD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06EB6FC-0C0E-EF03-143F-47A1E2DCA83F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365CFC7-2750-A3D0-9A2C-BA6CF14F107A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7CB78B5-4D86-3C7B-A4B9-DBAC835652E7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B94AF9E-FE5D-4F83-E067-C8A272D67B4A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EC63E63-7DF0-B5B0-E217-17819B9CF299}"/>
                </a:ext>
              </a:extLst>
            </p:cNvPr>
            <p:cNvSpPr txBox="1"/>
            <p:nvPr/>
          </p:nvSpPr>
          <p:spPr>
            <a:xfrm rot="18900000">
              <a:off x="3207885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3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6B4DC5C2-F5E8-B495-C1FE-61AEB334818F}"/>
              </a:ext>
            </a:extLst>
          </p:cNvPr>
          <p:cNvSpPr txBox="1"/>
          <p:nvPr/>
        </p:nvSpPr>
        <p:spPr>
          <a:xfrm>
            <a:off x="10540977" y="1520322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BCA1 </a:t>
            </a:r>
            <a:r>
              <a:rPr lang="en-US" altLang="zh-CN" dirty="0"/>
              <a:t>254</a:t>
            </a:r>
            <a:r>
              <a:rPr lang="en-US" dirty="0"/>
              <a:t>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C904952-570D-9B9A-15A3-963EDBC9B9F3}"/>
              </a:ext>
            </a:extLst>
          </p:cNvPr>
          <p:cNvSpPr txBox="1"/>
          <p:nvPr/>
        </p:nvSpPr>
        <p:spPr>
          <a:xfrm>
            <a:off x="4591411" y="2002036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BCG5 </a:t>
            </a:r>
            <a:r>
              <a:rPr lang="en-US" altLang="zh-CN" dirty="0"/>
              <a:t>72</a:t>
            </a:r>
            <a:r>
              <a:rPr lang="en-US" dirty="0"/>
              <a:t>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E5B407-616B-A5B6-D704-46CECAE98810}"/>
              </a:ext>
            </a:extLst>
          </p:cNvPr>
          <p:cNvSpPr txBox="1"/>
          <p:nvPr/>
        </p:nvSpPr>
        <p:spPr>
          <a:xfrm>
            <a:off x="10462773" y="2872024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BCG1 </a:t>
            </a:r>
            <a:r>
              <a:rPr lang="en-US" altLang="zh-CN" dirty="0"/>
              <a:t>76</a:t>
            </a:r>
            <a:r>
              <a:rPr lang="en-US" dirty="0"/>
              <a:t>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2A56BCA-8108-E316-C7E8-BBE58342A3E9}"/>
              </a:ext>
            </a:extLst>
          </p:cNvPr>
          <p:cNvSpPr txBox="1"/>
          <p:nvPr/>
        </p:nvSpPr>
        <p:spPr>
          <a:xfrm>
            <a:off x="10561842" y="5089381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586FAAB-7067-6276-6819-6348DC4CD34A}"/>
              </a:ext>
            </a:extLst>
          </p:cNvPr>
          <p:cNvSpPr txBox="1"/>
          <p:nvPr/>
        </p:nvSpPr>
        <p:spPr>
          <a:xfrm>
            <a:off x="4564452" y="3983264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6782C2D-9520-1452-B25E-1C3882F95086}"/>
              </a:ext>
            </a:extLst>
          </p:cNvPr>
          <p:cNvSpPr txBox="1"/>
          <p:nvPr/>
        </p:nvSpPr>
        <p:spPr>
          <a:xfrm>
            <a:off x="2176907" y="4848446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Tris Glycine ge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ACDD3CA-A3AA-1681-91C8-BFE093089103}"/>
              </a:ext>
            </a:extLst>
          </p:cNvPr>
          <p:cNvSpPr txBox="1"/>
          <p:nvPr/>
        </p:nvSpPr>
        <p:spPr>
          <a:xfrm>
            <a:off x="7510237" y="5892254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Tris Glycine ge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D3F2576-9A99-597A-347B-94E6CDDDD3A4}"/>
              </a:ext>
            </a:extLst>
          </p:cNvPr>
          <p:cNvSpPr txBox="1"/>
          <p:nvPr/>
        </p:nvSpPr>
        <p:spPr>
          <a:xfrm>
            <a:off x="2297240" y="285002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F-G</a:t>
            </a:r>
            <a:endParaRPr 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A8555C3-F133-0284-09CF-7198C1647F7C}"/>
              </a:ext>
            </a:extLst>
          </p:cNvPr>
          <p:cNvSpPr txBox="1"/>
          <p:nvPr/>
        </p:nvSpPr>
        <p:spPr>
          <a:xfrm>
            <a:off x="8256938" y="199104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F-G</a:t>
            </a:r>
            <a:endParaRPr lang="en-US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2E7A10-8CFE-8032-5322-85CF3A2B6801}"/>
              </a:ext>
            </a:extLst>
          </p:cNvPr>
          <p:cNvSpPr txBox="1"/>
          <p:nvPr/>
        </p:nvSpPr>
        <p:spPr>
          <a:xfrm>
            <a:off x="438298" y="6345537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3FAC6A4-5A35-F303-BA3D-C270D9AEC59B}"/>
              </a:ext>
            </a:extLst>
          </p:cNvPr>
          <p:cNvSpPr/>
          <p:nvPr/>
        </p:nvSpPr>
        <p:spPr>
          <a:xfrm>
            <a:off x="8101062" y="5127833"/>
            <a:ext cx="850604" cy="4146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3854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584ABF4-2564-92AA-1836-578EE491B8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4258" y="1699844"/>
            <a:ext cx="3779848" cy="179237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032D39C-9D57-171D-1B6F-0D074E319A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2327" y="3585827"/>
            <a:ext cx="3901778" cy="1944793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3201EBC4-8F9A-9419-5CF5-A74AFD9D33BC}"/>
              </a:ext>
            </a:extLst>
          </p:cNvPr>
          <p:cNvCxnSpPr/>
          <p:nvPr/>
        </p:nvCxnSpPr>
        <p:spPr>
          <a:xfrm>
            <a:off x="4544258" y="2268533"/>
            <a:ext cx="552896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38447C4C-5090-325D-CD3E-BAEEDC9A5E48}"/>
              </a:ext>
            </a:extLst>
          </p:cNvPr>
          <p:cNvSpPr/>
          <p:nvPr/>
        </p:nvSpPr>
        <p:spPr>
          <a:xfrm>
            <a:off x="5932588" y="2110949"/>
            <a:ext cx="881257" cy="315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B87EDFF-39C3-83B8-F303-7963FAAE3C35}"/>
              </a:ext>
            </a:extLst>
          </p:cNvPr>
          <p:cNvGrpSpPr/>
          <p:nvPr/>
        </p:nvGrpSpPr>
        <p:grpSpPr>
          <a:xfrm>
            <a:off x="5046218" y="1109184"/>
            <a:ext cx="3535254" cy="468754"/>
            <a:chOff x="970839" y="418953"/>
            <a:chExt cx="3535254" cy="46875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EF6C55A-0DE7-F147-94A6-29905A256ADC}"/>
                </a:ext>
              </a:extLst>
            </p:cNvPr>
            <p:cNvSpPr txBox="1"/>
            <p:nvPr/>
          </p:nvSpPr>
          <p:spPr>
            <a:xfrm rot="18900000">
              <a:off x="970839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EE008D0-A6D3-FD52-E656-723A1097183C}"/>
                </a:ext>
              </a:extLst>
            </p:cNvPr>
            <p:cNvSpPr txBox="1"/>
            <p:nvPr/>
          </p:nvSpPr>
          <p:spPr>
            <a:xfrm rot="18900000">
              <a:off x="1331621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1E470D5-FEC1-4E8C-EEF0-2AFA95075EF8}"/>
                </a:ext>
              </a:extLst>
            </p:cNvPr>
            <p:cNvSpPr txBox="1"/>
            <p:nvPr/>
          </p:nvSpPr>
          <p:spPr>
            <a:xfrm rot="18900000">
              <a:off x="1873168" y="518375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4D2C3FF-17CB-8D1B-7E33-A4CA10807B91}"/>
                </a:ext>
              </a:extLst>
            </p:cNvPr>
            <p:cNvSpPr txBox="1"/>
            <p:nvPr/>
          </p:nvSpPr>
          <p:spPr>
            <a:xfrm rot="18900000">
              <a:off x="2328496" y="418953"/>
              <a:ext cx="13246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 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418A4AC-0D91-AFB3-43CF-3CB9C3BE9B12}"/>
                </a:ext>
              </a:extLst>
            </p:cNvPr>
            <p:cNvSpPr txBox="1"/>
            <p:nvPr/>
          </p:nvSpPr>
          <p:spPr>
            <a:xfrm rot="18900000">
              <a:off x="2810926" y="516886"/>
              <a:ext cx="1047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C98B037-CA17-AABD-1872-54F0C81A6F68}"/>
                </a:ext>
              </a:extLst>
            </p:cNvPr>
            <p:cNvSpPr txBox="1"/>
            <p:nvPr/>
          </p:nvSpPr>
          <p:spPr>
            <a:xfrm rot="18900000">
              <a:off x="3234335" y="418953"/>
              <a:ext cx="12717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GC1A-KO3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613B73CD-98B0-68F3-52CB-A12811F36286}"/>
              </a:ext>
            </a:extLst>
          </p:cNvPr>
          <p:cNvSpPr txBox="1"/>
          <p:nvPr/>
        </p:nvSpPr>
        <p:spPr>
          <a:xfrm>
            <a:off x="5816841" y="2823713"/>
            <a:ext cx="1548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DLR </a:t>
            </a:r>
            <a:r>
              <a:rPr lang="en-US" altLang="zh-CN" dirty="0"/>
              <a:t>160kDa</a:t>
            </a:r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A7F568C-ED8C-7E70-B203-371ACD0AB6F4}"/>
              </a:ext>
            </a:extLst>
          </p:cNvPr>
          <p:cNvSpPr txBox="1"/>
          <p:nvPr/>
        </p:nvSpPr>
        <p:spPr>
          <a:xfrm>
            <a:off x="5654364" y="5189520"/>
            <a:ext cx="2318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38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B791098-F228-DEEF-DA10-43EF35896AE0}"/>
              </a:ext>
            </a:extLst>
          </p:cNvPr>
          <p:cNvSpPr txBox="1"/>
          <p:nvPr/>
        </p:nvSpPr>
        <p:spPr>
          <a:xfrm>
            <a:off x="5371073" y="5624224"/>
            <a:ext cx="259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Tris Glycine ge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B51DE1-EFF6-277B-2B2C-6089DF63C9E9}"/>
              </a:ext>
            </a:extLst>
          </p:cNvPr>
          <p:cNvSpPr txBox="1"/>
          <p:nvPr/>
        </p:nvSpPr>
        <p:spPr>
          <a:xfrm>
            <a:off x="6010701" y="315577"/>
            <a:ext cx="1796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or F</a:t>
            </a:r>
            <a:r>
              <a:rPr lang="en-US" altLang="zh-CN" b="1" dirty="0"/>
              <a:t>igure 5F-G</a:t>
            </a:r>
            <a:endParaRPr lang="en-US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715836A-A8C6-C92E-9E72-87AAEABB02B0}"/>
              </a:ext>
            </a:extLst>
          </p:cNvPr>
          <p:cNvSpPr txBox="1"/>
          <p:nvPr/>
        </p:nvSpPr>
        <p:spPr>
          <a:xfrm>
            <a:off x="4433443" y="6283298"/>
            <a:ext cx="6283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tein ladder information: </a:t>
            </a:r>
            <a:r>
              <a:rPr lang="en-US" dirty="0" err="1"/>
              <a:t>Smobio</a:t>
            </a:r>
            <a:r>
              <a:rPr lang="en-US" dirty="0"/>
              <a:t>  Cat:PM2700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D195EA9-5D33-7D20-D7F3-AE56B664893E}"/>
              </a:ext>
            </a:extLst>
          </p:cNvPr>
          <p:cNvSpPr/>
          <p:nvPr/>
        </p:nvSpPr>
        <p:spPr>
          <a:xfrm>
            <a:off x="5932588" y="4932717"/>
            <a:ext cx="881257" cy="315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938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6</TotalTime>
  <Words>931</Words>
  <Application>Microsoft Macintosh PowerPoint</Application>
  <PresentationFormat>Widescreen</PresentationFormat>
  <Paragraphs>371</Paragraphs>
  <Slides>1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yan Zhou</dc:creator>
  <cp:lastModifiedBy>Nady Celine Golestaneh</cp:lastModifiedBy>
  <cp:revision>37</cp:revision>
  <dcterms:created xsi:type="dcterms:W3CDTF">2023-01-19T03:37:50Z</dcterms:created>
  <dcterms:modified xsi:type="dcterms:W3CDTF">2024-05-16T21:02:39Z</dcterms:modified>
</cp:coreProperties>
</file>